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56" r:id="rId4"/>
    <p:sldId id="258" r:id="rId5"/>
    <p:sldId id="259" r:id="rId6"/>
    <p:sldId id="260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7447899-6E9E-B954-F80B-6EAAB7E45A49}" name="MDPI" initials="M" userId="MDPI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545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073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339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8924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287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8157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9030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589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5350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404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4285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7F972-2768-425D-A114-5B3F729B4801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2E133-A6F6-4FB7-A06E-76A3D3E988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7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openxmlformats.org/officeDocument/2006/relationships/image" Target="../media/image47.png"/><Relationship Id="rId18" Type="http://schemas.openxmlformats.org/officeDocument/2006/relationships/image" Target="../media/image52.png"/><Relationship Id="rId3" Type="http://schemas.openxmlformats.org/officeDocument/2006/relationships/image" Target="../media/image37.png"/><Relationship Id="rId21" Type="http://schemas.openxmlformats.org/officeDocument/2006/relationships/image" Target="../media/image55.png"/><Relationship Id="rId7" Type="http://schemas.openxmlformats.org/officeDocument/2006/relationships/image" Target="../media/image41.png"/><Relationship Id="rId12" Type="http://schemas.openxmlformats.org/officeDocument/2006/relationships/image" Target="../media/image46.png"/><Relationship Id="rId17" Type="http://schemas.openxmlformats.org/officeDocument/2006/relationships/image" Target="../media/image51.png"/><Relationship Id="rId2" Type="http://schemas.openxmlformats.org/officeDocument/2006/relationships/image" Target="../media/image36.png"/><Relationship Id="rId16" Type="http://schemas.openxmlformats.org/officeDocument/2006/relationships/image" Target="../media/image50.png"/><Relationship Id="rId20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11" Type="http://schemas.openxmlformats.org/officeDocument/2006/relationships/image" Target="../media/image45.png"/><Relationship Id="rId5" Type="http://schemas.openxmlformats.org/officeDocument/2006/relationships/image" Target="../media/image39.png"/><Relationship Id="rId15" Type="http://schemas.openxmlformats.org/officeDocument/2006/relationships/image" Target="../media/image49.png"/><Relationship Id="rId10" Type="http://schemas.openxmlformats.org/officeDocument/2006/relationships/image" Target="../media/image44.png"/><Relationship Id="rId19" Type="http://schemas.openxmlformats.org/officeDocument/2006/relationships/image" Target="../media/image53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Relationship Id="rId14" Type="http://schemas.openxmlformats.org/officeDocument/2006/relationships/image" Target="../media/image48.png"/><Relationship Id="rId22" Type="http://schemas.openxmlformats.org/officeDocument/2006/relationships/image" Target="../media/image5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openxmlformats.org/officeDocument/2006/relationships/image" Target="../media/image44.png"/><Relationship Id="rId18" Type="http://schemas.openxmlformats.org/officeDocument/2006/relationships/image" Target="../media/image70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12" Type="http://schemas.openxmlformats.org/officeDocument/2006/relationships/image" Target="../media/image66.png"/><Relationship Id="rId17" Type="http://schemas.openxmlformats.org/officeDocument/2006/relationships/image" Target="../media/image69.png"/><Relationship Id="rId2" Type="http://schemas.openxmlformats.org/officeDocument/2006/relationships/image" Target="../media/image57.png"/><Relationship Id="rId16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png"/><Relationship Id="rId11" Type="http://schemas.openxmlformats.org/officeDocument/2006/relationships/image" Target="../media/image42.png"/><Relationship Id="rId5" Type="http://schemas.openxmlformats.org/officeDocument/2006/relationships/image" Target="../media/image60.png"/><Relationship Id="rId15" Type="http://schemas.openxmlformats.org/officeDocument/2006/relationships/image" Target="../media/image68.png"/><Relationship Id="rId10" Type="http://schemas.openxmlformats.org/officeDocument/2006/relationships/image" Target="../media/image65.png"/><Relationship Id="rId19" Type="http://schemas.openxmlformats.org/officeDocument/2006/relationships/image" Target="../media/image41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Relationship Id="rId14" Type="http://schemas.openxmlformats.org/officeDocument/2006/relationships/image" Target="../media/image6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png"/><Relationship Id="rId13" Type="http://schemas.openxmlformats.org/officeDocument/2006/relationships/image" Target="../media/image82.png"/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12" Type="http://schemas.openxmlformats.org/officeDocument/2006/relationships/image" Target="../media/image81.png"/><Relationship Id="rId2" Type="http://schemas.openxmlformats.org/officeDocument/2006/relationships/image" Target="../media/image71.png"/><Relationship Id="rId16" Type="http://schemas.openxmlformats.org/officeDocument/2006/relationships/image" Target="../media/image8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png"/><Relationship Id="rId11" Type="http://schemas.openxmlformats.org/officeDocument/2006/relationships/image" Target="../media/image80.png"/><Relationship Id="rId5" Type="http://schemas.openxmlformats.org/officeDocument/2006/relationships/image" Target="../media/image74.png"/><Relationship Id="rId15" Type="http://schemas.openxmlformats.org/officeDocument/2006/relationships/image" Target="../media/image84.png"/><Relationship Id="rId10" Type="http://schemas.openxmlformats.org/officeDocument/2006/relationships/image" Target="../media/image79.png"/><Relationship Id="rId4" Type="http://schemas.openxmlformats.org/officeDocument/2006/relationships/image" Target="../media/image73.png"/><Relationship Id="rId9" Type="http://schemas.openxmlformats.org/officeDocument/2006/relationships/image" Target="../media/image78.png"/><Relationship Id="rId14" Type="http://schemas.openxmlformats.org/officeDocument/2006/relationships/image" Target="../media/image8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98566" y="260418"/>
            <a:ext cx="7878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1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perfused mitochondria in calcified VSMCs observed using translocase of mitochondrial outer membrane protein (TOM20) staining.</a:t>
            </a:r>
            <a:endParaRPr lang="en-GB" b="1" dirty="0">
              <a:highlight>
                <a:srgbClr val="FFFF00"/>
              </a:highlight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498567" y="828579"/>
            <a:ext cx="3749584" cy="3657696"/>
            <a:chOff x="498566" y="828579"/>
            <a:chExt cx="4381487" cy="432761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8566" y="828579"/>
              <a:ext cx="4381487" cy="4327616"/>
            </a:xfrm>
            <a:prstGeom prst="rect">
              <a:avLst/>
            </a:prstGeom>
          </p:spPr>
        </p:pic>
        <p:cxnSp>
          <p:nvCxnSpPr>
            <p:cNvPr id="8" name="Straight Connector 7"/>
            <p:cNvCxnSpPr/>
            <p:nvPr/>
          </p:nvCxnSpPr>
          <p:spPr>
            <a:xfrm>
              <a:off x="4418335" y="5013765"/>
              <a:ext cx="34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/>
          <p:cNvSpPr txBox="1"/>
          <p:nvPr/>
        </p:nvSpPr>
        <p:spPr>
          <a:xfrm>
            <a:off x="418012" y="4486274"/>
            <a:ext cx="17796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  <a:p>
            <a:r>
              <a:rPr lang="en-GB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78384" y="4486275"/>
            <a:ext cx="17796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  <a:p>
            <a:r>
              <a:rPr lang="en-GB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194718" y="800253"/>
            <a:ext cx="103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4478384" y="800253"/>
            <a:ext cx="4038652" cy="3686022"/>
            <a:chOff x="5087984" y="800253"/>
            <a:chExt cx="4038652" cy="368602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87984" y="828580"/>
              <a:ext cx="3703227" cy="3657695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7820026" y="800253"/>
              <a:ext cx="13066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mM P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27907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8342" y="182881"/>
            <a:ext cx="76226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2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wer hyperfused mitochondria were observed using translocase of mitochondrial outer membrane protein (TOM20) staining after p53 knockdown in calcified VSMC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17860" y="4676184"/>
            <a:ext cx="17796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  <a:p>
            <a:r>
              <a:rPr lang="en-GB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86791" y="4676183"/>
            <a:ext cx="17796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</a:p>
          <a:p>
            <a:r>
              <a:rPr lang="en-GB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343" y="1032223"/>
            <a:ext cx="3566118" cy="36439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321629" y="1032223"/>
            <a:ext cx="3498802" cy="369142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313042" y="1036834"/>
            <a:ext cx="1636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SC- siRN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218835" y="1006612"/>
            <a:ext cx="1947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p53- siRNA</a:t>
            </a:r>
          </a:p>
        </p:txBody>
      </p:sp>
    </p:spTree>
    <p:extLst>
      <p:ext uri="{BB962C8B-B14F-4D97-AF65-F5344CB8AC3E}">
        <p14:creationId xmlns:p14="http://schemas.microsoft.com/office/powerpoint/2010/main" val="42353298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16176" y="-24309"/>
            <a:ext cx="78947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3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blots for Figure 1B.</a:t>
            </a:r>
            <a:endParaRPr lang="en-GB" b="1" dirty="0"/>
          </a:p>
        </p:txBody>
      </p:sp>
      <p:pic>
        <p:nvPicPr>
          <p:cNvPr id="77" name="Picture 7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8336" y="644631"/>
            <a:ext cx="2122865" cy="1453567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0482" y="2425873"/>
            <a:ext cx="2080719" cy="1473149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8761201" y="1151479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3</a:t>
            </a:r>
          </a:p>
        </p:txBody>
      </p:sp>
      <p:pic>
        <p:nvPicPr>
          <p:cNvPr id="91" name="Picture 9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38336" y="4314559"/>
            <a:ext cx="1568222" cy="156530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8841673" y="3003260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3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950530" y="5047568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3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335196" y="2691827"/>
            <a:ext cx="2036603" cy="1694332"/>
            <a:chOff x="335196" y="2691827"/>
            <a:chExt cx="2036603" cy="169433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96397" y="2691827"/>
              <a:ext cx="1475402" cy="1694332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335196" y="2828654"/>
              <a:ext cx="1122402" cy="1485905"/>
              <a:chOff x="3931931" y="1205922"/>
              <a:chExt cx="1122402" cy="1485905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991282" y="1343253"/>
                <a:ext cx="1063051" cy="1348574"/>
                <a:chOff x="3991282" y="1343253"/>
                <a:chExt cx="1063051" cy="1348574"/>
              </a:xfrm>
            </p:grpSpPr>
            <p:sp>
              <p:nvSpPr>
                <p:cNvPr id="53" name="TextBox 52"/>
                <p:cNvSpPr txBox="1"/>
                <p:nvPr/>
              </p:nvSpPr>
              <p:spPr>
                <a:xfrm>
                  <a:off x="3991282" y="1343253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7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4024011" y="1690238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50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4024011" y="1858895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37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4004870" y="2078402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2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4024011" y="2257333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20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4044907" y="2445606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1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</p:grpSp>
          <p:sp>
            <p:nvSpPr>
              <p:cNvPr id="59" name="TextBox 58"/>
              <p:cNvSpPr txBox="1"/>
              <p:nvPr/>
            </p:nvSpPr>
            <p:spPr>
              <a:xfrm>
                <a:off x="3931931" y="120592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</p:grpSp>
      </p:grpSp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4035" y="762694"/>
            <a:ext cx="1639029" cy="1607247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349136" y="4930185"/>
            <a:ext cx="1971684" cy="1719404"/>
            <a:chOff x="349136" y="4930185"/>
            <a:chExt cx="1971684" cy="171940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91952" y="4930185"/>
              <a:ext cx="1428868" cy="1719404"/>
            </a:xfrm>
            <a:prstGeom prst="rect">
              <a:avLst/>
            </a:prstGeom>
          </p:spPr>
        </p:pic>
        <p:grpSp>
          <p:nvGrpSpPr>
            <p:cNvPr id="112" name="Group 111"/>
            <p:cNvGrpSpPr/>
            <p:nvPr/>
          </p:nvGrpSpPr>
          <p:grpSpPr>
            <a:xfrm>
              <a:off x="349136" y="5136914"/>
              <a:ext cx="1087566" cy="1485905"/>
              <a:chOff x="3966767" y="1205922"/>
              <a:chExt cx="1087566" cy="1485905"/>
            </a:xfrm>
          </p:grpSpPr>
          <p:grpSp>
            <p:nvGrpSpPr>
              <p:cNvPr id="113" name="Group 112"/>
              <p:cNvGrpSpPr/>
              <p:nvPr/>
            </p:nvGrpSpPr>
            <p:grpSpPr>
              <a:xfrm>
                <a:off x="3991282" y="1343253"/>
                <a:ext cx="1063051" cy="1348574"/>
                <a:chOff x="3991282" y="1343253"/>
                <a:chExt cx="1063051" cy="1348574"/>
              </a:xfrm>
            </p:grpSpPr>
            <p:sp>
              <p:nvSpPr>
                <p:cNvPr id="115" name="TextBox 114"/>
                <p:cNvSpPr txBox="1"/>
                <p:nvPr/>
              </p:nvSpPr>
              <p:spPr>
                <a:xfrm>
                  <a:off x="3991282" y="1343253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7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4044907" y="1573126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50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4044907" y="1746287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37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4044907" y="1956452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2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4044907" y="2132417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20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4044907" y="2445606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1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</p:grpSp>
          <p:sp>
            <p:nvSpPr>
              <p:cNvPr id="114" name="TextBox 113"/>
              <p:cNvSpPr txBox="1"/>
              <p:nvPr/>
            </p:nvSpPr>
            <p:spPr>
              <a:xfrm>
                <a:off x="3966767" y="120592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</p:grpSp>
      </p:grpSp>
      <p:sp>
        <p:nvSpPr>
          <p:cNvPr id="161" name="TextBox 160"/>
          <p:cNvSpPr txBox="1"/>
          <p:nvPr/>
        </p:nvSpPr>
        <p:spPr>
          <a:xfrm>
            <a:off x="6889431" y="483439"/>
            <a:ext cx="143653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Control   3mM Pi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38871" y="2592847"/>
            <a:ext cx="2326407" cy="1566386"/>
          </a:xfrm>
          <a:prstGeom prst="rect">
            <a:avLst/>
          </a:prstGeom>
        </p:spPr>
      </p:pic>
      <p:pic>
        <p:nvPicPr>
          <p:cNvPr id="179" name="Picture 17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67490" y="4512766"/>
            <a:ext cx="2700134" cy="1973390"/>
          </a:xfrm>
          <a:prstGeom prst="rect">
            <a:avLst/>
          </a:prstGeom>
        </p:spPr>
      </p:pic>
      <p:grpSp>
        <p:nvGrpSpPr>
          <p:cNvPr id="37" name="Group 36"/>
          <p:cNvGrpSpPr/>
          <p:nvPr/>
        </p:nvGrpSpPr>
        <p:grpSpPr>
          <a:xfrm>
            <a:off x="3909897" y="509990"/>
            <a:ext cx="2055381" cy="1922643"/>
            <a:chOff x="6148072" y="1462223"/>
            <a:chExt cx="2602891" cy="2045589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148072" y="1636692"/>
              <a:ext cx="1125384" cy="18711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9" name="Group 38"/>
            <p:cNvGrpSpPr/>
            <p:nvPr/>
          </p:nvGrpSpPr>
          <p:grpSpPr>
            <a:xfrm>
              <a:off x="7170747" y="2205896"/>
              <a:ext cx="1580216" cy="276999"/>
              <a:chOff x="8046203" y="4579013"/>
              <a:chExt cx="1580216" cy="276999"/>
            </a:xfrm>
          </p:grpSpPr>
          <p:cxnSp>
            <p:nvCxnSpPr>
              <p:cNvPr id="41" name="Straight Arrow Connector 40"/>
              <p:cNvCxnSpPr/>
              <p:nvPr/>
            </p:nvCxnSpPr>
            <p:spPr>
              <a:xfrm flipH="1">
                <a:off x="8046203" y="4724351"/>
                <a:ext cx="38004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8354967" y="4579013"/>
                <a:ext cx="12714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NAP</a:t>
                </a: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6441451" y="1462223"/>
              <a:ext cx="1436533" cy="196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  3mM Pi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3419738" y="646562"/>
            <a:ext cx="1122402" cy="1705075"/>
            <a:chOff x="3371566" y="603450"/>
            <a:chExt cx="1122402" cy="1705075"/>
          </a:xfrm>
        </p:grpSpPr>
        <p:grpSp>
          <p:nvGrpSpPr>
            <p:cNvPr id="11" name="Group 10"/>
            <p:cNvGrpSpPr/>
            <p:nvPr/>
          </p:nvGrpSpPr>
          <p:grpSpPr>
            <a:xfrm>
              <a:off x="3371566" y="853397"/>
              <a:ext cx="1122402" cy="1455128"/>
              <a:chOff x="3432529" y="853397"/>
              <a:chExt cx="1122402" cy="1455128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3491880" y="99072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524609" y="1337713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524609" y="150637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505468" y="172587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524609" y="190480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545505" y="209308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432529" y="85339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3371566" y="60345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371566" y="75594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000049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442" y="-68687"/>
            <a:ext cx="6078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4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ll length blots for Figure 3A, 3D and 3E.</a:t>
            </a:r>
            <a:endParaRPr lang="en-GB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0" y="230874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3 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097583" y="-33555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3 D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786612" y="2283333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3 E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1941010" y="4979540"/>
            <a:ext cx="1359538" cy="1480067"/>
            <a:chOff x="3622953" y="2645103"/>
            <a:chExt cx="1359538" cy="148006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22953" y="2645103"/>
              <a:ext cx="473621" cy="14800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2" name="TextBox 91"/>
            <p:cNvSpPr txBox="1"/>
            <p:nvPr/>
          </p:nvSpPr>
          <p:spPr>
            <a:xfrm>
              <a:off x="4278521" y="3335437"/>
              <a:ext cx="70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ACTB</a:t>
              </a:r>
            </a:p>
          </p:txBody>
        </p:sp>
        <p:cxnSp>
          <p:nvCxnSpPr>
            <p:cNvPr id="93" name="Straight Arrow Connector 92"/>
            <p:cNvCxnSpPr/>
            <p:nvPr/>
          </p:nvCxnSpPr>
          <p:spPr>
            <a:xfrm flipH="1">
              <a:off x="4045457" y="3478938"/>
              <a:ext cx="2973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oup 125"/>
          <p:cNvGrpSpPr/>
          <p:nvPr/>
        </p:nvGrpSpPr>
        <p:grpSpPr>
          <a:xfrm>
            <a:off x="162532" y="583474"/>
            <a:ext cx="2127823" cy="1986327"/>
            <a:chOff x="162532" y="583474"/>
            <a:chExt cx="2127823" cy="1986327"/>
          </a:xfrm>
        </p:grpSpPr>
        <p:grpSp>
          <p:nvGrpSpPr>
            <p:cNvPr id="125" name="Group 124"/>
            <p:cNvGrpSpPr/>
            <p:nvPr/>
          </p:nvGrpSpPr>
          <p:grpSpPr>
            <a:xfrm>
              <a:off x="175120" y="583474"/>
              <a:ext cx="2115235" cy="1986327"/>
              <a:chOff x="175120" y="583474"/>
              <a:chExt cx="2115235" cy="1986327"/>
            </a:xfrm>
          </p:grpSpPr>
          <p:pic>
            <p:nvPicPr>
              <p:cNvPr id="117" name="Picture 116"/>
              <p:cNvPicPr>
                <a:picLocks noChangeAspect="1"/>
              </p:cNvPicPr>
              <p:nvPr/>
            </p:nvPicPr>
            <p:blipFill rotWithShape="1">
              <a:blip r:embed="rId3"/>
              <a:srcRect t="-5400" r="21404" b="-2"/>
              <a:stretch/>
            </p:blipFill>
            <p:spPr>
              <a:xfrm>
                <a:off x="712359" y="583474"/>
                <a:ext cx="1577996" cy="1986327"/>
              </a:xfrm>
              <a:prstGeom prst="rect">
                <a:avLst/>
              </a:prstGeom>
            </p:spPr>
          </p:pic>
          <p:sp>
            <p:nvSpPr>
              <p:cNvPr id="118" name="TextBox 117"/>
              <p:cNvSpPr txBox="1"/>
              <p:nvPr/>
            </p:nvSpPr>
            <p:spPr>
              <a:xfrm>
                <a:off x="207645" y="1976966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207645" y="2241404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 8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224579" y="1351055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213983" y="1621511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230916" y="1129364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9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175120" y="880134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6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</p:grpSp>
        <p:sp>
          <p:nvSpPr>
            <p:cNvPr id="123" name="TextBox 122"/>
            <p:cNvSpPr txBox="1"/>
            <p:nvPr/>
          </p:nvSpPr>
          <p:spPr>
            <a:xfrm>
              <a:off x="162532" y="994136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6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133" name="Group 132"/>
          <p:cNvGrpSpPr/>
          <p:nvPr/>
        </p:nvGrpSpPr>
        <p:grpSpPr>
          <a:xfrm>
            <a:off x="1534598" y="2843583"/>
            <a:ext cx="1979425" cy="1767412"/>
            <a:chOff x="3678401" y="730724"/>
            <a:chExt cx="1979425" cy="1767412"/>
          </a:xfrm>
        </p:grpSpPr>
        <p:pic>
          <p:nvPicPr>
            <p:cNvPr id="131" name="Picture 13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52938" y="730724"/>
              <a:ext cx="1504888" cy="1767412"/>
            </a:xfrm>
            <a:prstGeom prst="rect">
              <a:avLst/>
            </a:prstGeom>
          </p:spPr>
        </p:pic>
        <p:sp>
          <p:nvSpPr>
            <p:cNvPr id="132" name="TextBox 131"/>
            <p:cNvSpPr txBox="1"/>
            <p:nvPr/>
          </p:nvSpPr>
          <p:spPr>
            <a:xfrm>
              <a:off x="3678401" y="1621511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pic>
        <p:nvPicPr>
          <p:cNvPr id="46" name="Picture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5511" y="2879028"/>
            <a:ext cx="1311808" cy="1910066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7377" y="4856843"/>
            <a:ext cx="1415838" cy="1854031"/>
          </a:xfrm>
          <a:prstGeom prst="rect">
            <a:avLst/>
          </a:prstGeom>
        </p:spPr>
      </p:pic>
      <p:pic>
        <p:nvPicPr>
          <p:cNvPr id="151" name="Picture 150"/>
          <p:cNvPicPr>
            <a:picLocks noChangeAspect="1"/>
          </p:cNvPicPr>
          <p:nvPr/>
        </p:nvPicPr>
        <p:blipFill rotWithShape="1">
          <a:blip r:embed="rId7"/>
          <a:srcRect l="18671" t="7464"/>
          <a:stretch/>
        </p:blipFill>
        <p:spPr>
          <a:xfrm>
            <a:off x="7835153" y="484094"/>
            <a:ext cx="1688089" cy="1812008"/>
          </a:xfrm>
          <a:prstGeom prst="rect">
            <a:avLst/>
          </a:prstGeom>
        </p:spPr>
      </p:pic>
      <p:sp>
        <p:nvSpPr>
          <p:cNvPr id="152" name="Rectangle 151"/>
          <p:cNvSpPr/>
          <p:nvPr/>
        </p:nvSpPr>
        <p:spPr>
          <a:xfrm>
            <a:off x="1489372" y="5667842"/>
            <a:ext cx="5517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42kDa -</a:t>
            </a:r>
            <a:endParaRPr lang="en-GB" sz="800" dirty="0"/>
          </a:p>
        </p:txBody>
      </p:sp>
      <p:grpSp>
        <p:nvGrpSpPr>
          <p:cNvPr id="156" name="Group 155"/>
          <p:cNvGrpSpPr/>
          <p:nvPr/>
        </p:nvGrpSpPr>
        <p:grpSpPr>
          <a:xfrm>
            <a:off x="3375807" y="3396121"/>
            <a:ext cx="3725229" cy="1030180"/>
            <a:chOff x="3375807" y="3396121"/>
            <a:chExt cx="3725229" cy="1030180"/>
          </a:xfrm>
        </p:grpSpPr>
        <p:grpSp>
          <p:nvGrpSpPr>
            <p:cNvPr id="141" name="Group 140"/>
            <p:cNvGrpSpPr/>
            <p:nvPr/>
          </p:nvGrpSpPr>
          <p:grpSpPr>
            <a:xfrm>
              <a:off x="3375807" y="3396121"/>
              <a:ext cx="3725229" cy="1030180"/>
              <a:chOff x="3247588" y="809083"/>
              <a:chExt cx="3725229" cy="1030180"/>
            </a:xfrm>
          </p:grpSpPr>
          <p:grpSp>
            <p:nvGrpSpPr>
              <p:cNvPr id="140" name="Group 139"/>
              <p:cNvGrpSpPr/>
              <p:nvPr/>
            </p:nvGrpSpPr>
            <p:grpSpPr>
              <a:xfrm>
                <a:off x="3247588" y="813702"/>
                <a:ext cx="2326293" cy="1025561"/>
                <a:chOff x="7927588" y="236182"/>
                <a:chExt cx="2326293" cy="1025561"/>
              </a:xfrm>
            </p:grpSpPr>
            <p:grpSp>
              <p:nvGrpSpPr>
                <p:cNvPr id="14" name="Group 13"/>
                <p:cNvGrpSpPr/>
                <p:nvPr/>
              </p:nvGrpSpPr>
              <p:grpSpPr>
                <a:xfrm>
                  <a:off x="8407138" y="236182"/>
                  <a:ext cx="1846743" cy="1025561"/>
                  <a:chOff x="859432" y="2028326"/>
                  <a:chExt cx="1846743" cy="1025561"/>
                </a:xfrm>
              </p:grpSpPr>
              <p:pic>
                <p:nvPicPr>
                  <p:cNvPr id="5" name="Picture 4"/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65287" t="298" r="1472" b="1"/>
                  <a:stretch/>
                </p:blipFill>
                <p:spPr>
                  <a:xfrm>
                    <a:off x="859432" y="2048267"/>
                    <a:ext cx="862643" cy="100562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cxnSp>
                <p:nvCxnSpPr>
                  <p:cNvPr id="9" name="Straight Arrow Connector 8"/>
                  <p:cNvCxnSpPr/>
                  <p:nvPr/>
                </p:nvCxnSpPr>
                <p:spPr>
                  <a:xfrm flipH="1">
                    <a:off x="1624426" y="2163633"/>
                    <a:ext cx="298677" cy="4513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1867893" y="2028326"/>
                    <a:ext cx="83828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/>
                      <a:t>DRP1</a:t>
                    </a:r>
                  </a:p>
                </p:txBody>
              </p:sp>
            </p:grpSp>
            <p:sp>
              <p:nvSpPr>
                <p:cNvPr id="20" name="TextBox 19"/>
                <p:cNvSpPr txBox="1"/>
                <p:nvPr/>
              </p:nvSpPr>
              <p:spPr>
                <a:xfrm>
                  <a:off x="7927588" y="296774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75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7927588" y="635318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50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7927588" y="907832"/>
                  <a:ext cx="1009426" cy="2252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/>
                    <a:t>37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</p:grp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488363" y="809083"/>
                <a:ext cx="582419" cy="7569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7" name="TextBox 106"/>
              <p:cNvSpPr txBox="1"/>
              <p:nvPr/>
            </p:nvSpPr>
            <p:spPr>
              <a:xfrm>
                <a:off x="6268847" y="1130151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ACTB</a:t>
                </a:r>
              </a:p>
            </p:txBody>
          </p:sp>
          <p:cxnSp>
            <p:nvCxnSpPr>
              <p:cNvPr id="108" name="Straight Arrow Connector 107"/>
              <p:cNvCxnSpPr/>
              <p:nvPr/>
            </p:nvCxnSpPr>
            <p:spPr>
              <a:xfrm flipH="1">
                <a:off x="6035783" y="1273652"/>
                <a:ext cx="29738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3" name="Rectangle 152"/>
            <p:cNvSpPr/>
            <p:nvPr/>
          </p:nvSpPr>
          <p:spPr>
            <a:xfrm>
              <a:off x="5158147" y="3775016"/>
              <a:ext cx="5517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800" dirty="0"/>
            </a:p>
          </p:txBody>
        </p:sp>
      </p:grpSp>
      <p:grpSp>
        <p:nvGrpSpPr>
          <p:cNvPr id="155" name="Group 154"/>
          <p:cNvGrpSpPr/>
          <p:nvPr/>
        </p:nvGrpSpPr>
        <p:grpSpPr>
          <a:xfrm>
            <a:off x="3889290" y="5108976"/>
            <a:ext cx="3086787" cy="1141141"/>
            <a:chOff x="3889290" y="5108976"/>
            <a:chExt cx="3086787" cy="1141141"/>
          </a:xfrm>
        </p:grpSpPr>
        <p:grpSp>
          <p:nvGrpSpPr>
            <p:cNvPr id="142" name="Group 141"/>
            <p:cNvGrpSpPr/>
            <p:nvPr/>
          </p:nvGrpSpPr>
          <p:grpSpPr>
            <a:xfrm>
              <a:off x="3889290" y="5108976"/>
              <a:ext cx="3086787" cy="1141141"/>
              <a:chOff x="3840191" y="2437221"/>
              <a:chExt cx="3086787" cy="1141141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462447" y="2506323"/>
                <a:ext cx="534816" cy="9601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7" name="Group 16"/>
              <p:cNvGrpSpPr/>
              <p:nvPr/>
            </p:nvGrpSpPr>
            <p:grpSpPr>
              <a:xfrm>
                <a:off x="3840191" y="2437221"/>
                <a:ext cx="1916099" cy="1141141"/>
                <a:chOff x="10083902" y="438203"/>
                <a:chExt cx="1916099" cy="1141141"/>
              </a:xfrm>
            </p:grpSpPr>
            <p:sp>
              <p:nvSpPr>
                <p:cNvPr id="23" name="TextBox 22"/>
                <p:cNvSpPr txBox="1"/>
                <p:nvPr/>
              </p:nvSpPr>
              <p:spPr>
                <a:xfrm>
                  <a:off x="10199985" y="438203"/>
                  <a:ext cx="143653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   3mM Pi</a:t>
                  </a:r>
                </a:p>
              </p:txBody>
            </p:sp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0083902" y="595864"/>
                  <a:ext cx="818759" cy="98348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05" name="Straight Arrow Connector 104"/>
                <p:cNvCxnSpPr/>
                <p:nvPr/>
              </p:nvCxnSpPr>
              <p:spPr>
                <a:xfrm flipH="1">
                  <a:off x="10918252" y="715356"/>
                  <a:ext cx="298677" cy="451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TextBox 105"/>
                <p:cNvSpPr txBox="1"/>
                <p:nvPr/>
              </p:nvSpPr>
              <p:spPr>
                <a:xfrm>
                  <a:off x="11161719" y="580049"/>
                  <a:ext cx="8382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DRP1</a:t>
                  </a:r>
                </a:p>
              </p:txBody>
            </p:sp>
          </p:grpSp>
          <p:sp>
            <p:nvSpPr>
              <p:cNvPr id="109" name="TextBox 108"/>
              <p:cNvSpPr txBox="1"/>
              <p:nvPr/>
            </p:nvSpPr>
            <p:spPr>
              <a:xfrm>
                <a:off x="6223008" y="2818819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ACTB</a:t>
                </a:r>
              </a:p>
            </p:txBody>
          </p:sp>
          <p:cxnSp>
            <p:nvCxnSpPr>
              <p:cNvPr id="110" name="Straight Arrow Connector 109"/>
              <p:cNvCxnSpPr/>
              <p:nvPr/>
            </p:nvCxnSpPr>
            <p:spPr>
              <a:xfrm flipH="1">
                <a:off x="5989944" y="2962320"/>
                <a:ext cx="29738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" name="Rectangle 153"/>
            <p:cNvSpPr/>
            <p:nvPr/>
          </p:nvSpPr>
          <p:spPr>
            <a:xfrm>
              <a:off x="5003625" y="5511593"/>
              <a:ext cx="83950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800" dirty="0"/>
            </a:p>
          </p:txBody>
        </p:sp>
      </p:grpSp>
      <p:sp>
        <p:nvSpPr>
          <p:cNvPr id="66" name="TextBox 65"/>
          <p:cNvSpPr txBox="1"/>
          <p:nvPr/>
        </p:nvSpPr>
        <p:spPr>
          <a:xfrm>
            <a:off x="2293576" y="1256311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3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334602" y="2664784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3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4334602" y="4633809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3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7413686" y="2726271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1 of 3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8509043" y="2696850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2 of 3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9801325" y="2685300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3 of 3</a:t>
            </a:r>
          </a:p>
        </p:txBody>
      </p:sp>
      <p:grpSp>
        <p:nvGrpSpPr>
          <p:cNvPr id="72" name="Group 71"/>
          <p:cNvGrpSpPr/>
          <p:nvPr/>
        </p:nvGrpSpPr>
        <p:grpSpPr>
          <a:xfrm>
            <a:off x="6945125" y="578840"/>
            <a:ext cx="1538043" cy="2444595"/>
            <a:chOff x="776433" y="949273"/>
            <a:chExt cx="1538043" cy="2444595"/>
          </a:xfrm>
        </p:grpSpPr>
        <p:grpSp>
          <p:nvGrpSpPr>
            <p:cNvPr id="73" name="Group 72"/>
            <p:cNvGrpSpPr/>
            <p:nvPr/>
          </p:nvGrpSpPr>
          <p:grpSpPr>
            <a:xfrm>
              <a:off x="776433" y="949273"/>
              <a:ext cx="1526091" cy="2444595"/>
              <a:chOff x="1995516" y="4984173"/>
              <a:chExt cx="1526091" cy="2444595"/>
            </a:xfrm>
          </p:grpSpPr>
          <p:grpSp>
            <p:nvGrpSpPr>
              <p:cNvPr id="75" name="Group 74"/>
              <p:cNvGrpSpPr/>
              <p:nvPr/>
            </p:nvGrpSpPr>
            <p:grpSpPr>
              <a:xfrm>
                <a:off x="2387042" y="4984173"/>
                <a:ext cx="1134565" cy="1429796"/>
                <a:chOff x="10899914" y="455650"/>
                <a:chExt cx="1134565" cy="1429796"/>
              </a:xfrm>
            </p:grpSpPr>
            <p:sp>
              <p:nvSpPr>
                <p:cNvPr id="80" name="TextBox 79"/>
                <p:cNvSpPr txBox="1"/>
                <p:nvPr/>
              </p:nvSpPr>
              <p:spPr>
                <a:xfrm>
                  <a:off x="10912961" y="455650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10899914" y="567695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10906438" y="732252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 10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10976949" y="834265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7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10976949" y="1078385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11013101" y="1228858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37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11025053" y="1419794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11013498" y="1670002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</p:grpSp>
          <p:sp>
            <p:nvSpPr>
              <p:cNvPr id="76" name="TextBox 75"/>
              <p:cNvSpPr txBox="1"/>
              <p:nvPr/>
            </p:nvSpPr>
            <p:spPr>
              <a:xfrm>
                <a:off x="1995516" y="7213324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74" name="TextBox 73"/>
            <p:cNvSpPr txBox="1"/>
            <p:nvPr/>
          </p:nvSpPr>
          <p:spPr>
            <a:xfrm>
              <a:off x="1305050" y="204933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7075958" y="3279617"/>
            <a:ext cx="1144857" cy="1262310"/>
            <a:chOff x="1166435" y="976168"/>
            <a:chExt cx="1144857" cy="1262310"/>
          </a:xfrm>
        </p:grpSpPr>
        <p:grpSp>
          <p:nvGrpSpPr>
            <p:cNvPr id="91" name="Group 90"/>
            <p:cNvGrpSpPr/>
            <p:nvPr/>
          </p:nvGrpSpPr>
          <p:grpSpPr>
            <a:xfrm>
              <a:off x="1166435" y="976168"/>
              <a:ext cx="1144857" cy="1262310"/>
              <a:chOff x="10898390" y="482545"/>
              <a:chExt cx="1144857" cy="1262310"/>
            </a:xfrm>
          </p:grpSpPr>
          <p:sp>
            <p:nvSpPr>
              <p:cNvPr id="95" name="TextBox 94"/>
              <p:cNvSpPr txBox="1"/>
              <p:nvPr/>
            </p:nvSpPr>
            <p:spPr>
              <a:xfrm>
                <a:off x="10939856" y="48254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10898390" y="56701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 1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10924717" y="68729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10993167" y="78128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11013101" y="95975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11013101" y="110236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11025053" y="130994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1033821" y="152941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1301866" y="189464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03" name="TextBox 102"/>
          <p:cNvSpPr txBox="1"/>
          <p:nvPr/>
        </p:nvSpPr>
        <p:spPr>
          <a:xfrm>
            <a:off x="7202245" y="4495399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grpSp>
        <p:nvGrpSpPr>
          <p:cNvPr id="104" name="Group 103"/>
          <p:cNvGrpSpPr/>
          <p:nvPr/>
        </p:nvGrpSpPr>
        <p:grpSpPr>
          <a:xfrm>
            <a:off x="7067190" y="4791745"/>
            <a:ext cx="1156189" cy="1601224"/>
            <a:chOff x="1166435" y="976168"/>
            <a:chExt cx="1156189" cy="1601224"/>
          </a:xfrm>
        </p:grpSpPr>
        <p:grpSp>
          <p:nvGrpSpPr>
            <p:cNvPr id="111" name="Group 110"/>
            <p:cNvGrpSpPr/>
            <p:nvPr/>
          </p:nvGrpSpPr>
          <p:grpSpPr>
            <a:xfrm>
              <a:off x="1166435" y="976168"/>
              <a:ext cx="1136612" cy="1459972"/>
              <a:chOff x="10898390" y="482545"/>
              <a:chExt cx="1136612" cy="1459972"/>
            </a:xfrm>
          </p:grpSpPr>
          <p:sp>
            <p:nvSpPr>
              <p:cNvPr id="115" name="TextBox 114"/>
              <p:cNvSpPr txBox="1"/>
              <p:nvPr/>
            </p:nvSpPr>
            <p:spPr>
              <a:xfrm>
                <a:off x="10924717" y="68729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10993167" y="78128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10939856" y="48254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10898390" y="56701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 1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11013101" y="95975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1013101" y="110236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11025053" y="130994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11025576" y="1727073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112" name="TextBox 111"/>
            <p:cNvSpPr txBox="1"/>
            <p:nvPr/>
          </p:nvSpPr>
          <p:spPr>
            <a:xfrm>
              <a:off x="1313198" y="236194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43" name="TextBox 142"/>
          <p:cNvSpPr txBox="1"/>
          <p:nvPr/>
        </p:nvSpPr>
        <p:spPr>
          <a:xfrm>
            <a:off x="7188010" y="5872414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grpSp>
        <p:nvGrpSpPr>
          <p:cNvPr id="145" name="Group 144"/>
          <p:cNvGrpSpPr/>
          <p:nvPr/>
        </p:nvGrpSpPr>
        <p:grpSpPr>
          <a:xfrm>
            <a:off x="135212" y="4966927"/>
            <a:ext cx="1124137" cy="1567517"/>
            <a:chOff x="10898390" y="482545"/>
            <a:chExt cx="1124137" cy="1567517"/>
          </a:xfrm>
        </p:grpSpPr>
        <p:sp>
          <p:nvSpPr>
            <p:cNvPr id="147" name="TextBox 146"/>
            <p:cNvSpPr txBox="1"/>
            <p:nvPr/>
          </p:nvSpPr>
          <p:spPr>
            <a:xfrm>
              <a:off x="10939856" y="482545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10898390" y="56701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 1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0924717" y="68729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0993167" y="78128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11013101" y="109944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1013101" y="1285809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10997177" y="154070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1001561" y="183461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65" name="TextBox 164"/>
          <p:cNvSpPr txBox="1"/>
          <p:nvPr/>
        </p:nvSpPr>
        <p:spPr>
          <a:xfrm>
            <a:off x="238383" y="6132810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3388634" y="5303374"/>
            <a:ext cx="1009426" cy="225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7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3414907" y="5633175"/>
            <a:ext cx="1009426" cy="225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5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3414907" y="5905689"/>
            <a:ext cx="1009426" cy="225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37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69" name="TextBox 168"/>
          <p:cNvSpPr txBox="1"/>
          <p:nvPr/>
        </p:nvSpPr>
        <p:spPr>
          <a:xfrm>
            <a:off x="161371" y="4065068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1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0" name="TextBox 169"/>
          <p:cNvSpPr txBox="1"/>
          <p:nvPr/>
        </p:nvSpPr>
        <p:spPr>
          <a:xfrm>
            <a:off x="161371" y="4329506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 8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1" name="TextBox 170"/>
          <p:cNvSpPr txBox="1"/>
          <p:nvPr/>
        </p:nvSpPr>
        <p:spPr>
          <a:xfrm>
            <a:off x="178305" y="3439157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5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2" name="TextBox 171"/>
          <p:cNvSpPr txBox="1"/>
          <p:nvPr/>
        </p:nvSpPr>
        <p:spPr>
          <a:xfrm>
            <a:off x="167709" y="3709613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2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3" name="TextBox 172"/>
          <p:cNvSpPr txBox="1"/>
          <p:nvPr/>
        </p:nvSpPr>
        <p:spPr>
          <a:xfrm>
            <a:off x="184642" y="3217466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9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116258" y="3082238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16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1534598" y="4315347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1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1547963" y="3986367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2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1558222" y="3472646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9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79" name="Rectangle 178"/>
          <p:cNvSpPr/>
          <p:nvPr/>
        </p:nvSpPr>
        <p:spPr>
          <a:xfrm>
            <a:off x="1208110" y="1167564"/>
            <a:ext cx="462224" cy="542621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65670" y="531517"/>
            <a:ext cx="1203256" cy="238007"/>
          </a:xfrm>
          <a:prstGeom prst="rect">
            <a:avLst/>
          </a:prstGeom>
        </p:spPr>
      </p:pic>
      <p:sp>
        <p:nvSpPr>
          <p:cNvPr id="183" name="TextBox 182"/>
          <p:cNvSpPr txBox="1"/>
          <p:nvPr/>
        </p:nvSpPr>
        <p:spPr>
          <a:xfrm>
            <a:off x="3896200" y="3231580"/>
            <a:ext cx="1436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   3mM Pi</a:t>
            </a:r>
          </a:p>
        </p:txBody>
      </p:sp>
      <p:sp>
        <p:nvSpPr>
          <p:cNvPr id="184" name="TextBox 183"/>
          <p:cNvSpPr txBox="1"/>
          <p:nvPr/>
        </p:nvSpPr>
        <p:spPr>
          <a:xfrm>
            <a:off x="5449503" y="3201524"/>
            <a:ext cx="1436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   3mM Pi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5332641" y="5009603"/>
            <a:ext cx="1436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   3mM Pi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871452" y="399370"/>
            <a:ext cx="844132" cy="135919"/>
          </a:xfrm>
          <a:prstGeom prst="rect">
            <a:avLst/>
          </a:prstGeom>
        </p:spPr>
      </p:pic>
      <p:pic>
        <p:nvPicPr>
          <p:cNvPr id="187" name="Picture 18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25791" y="403699"/>
            <a:ext cx="844132" cy="135919"/>
          </a:xfrm>
          <a:prstGeom prst="rect">
            <a:avLst/>
          </a:prstGeom>
        </p:spPr>
      </p:pic>
      <p:sp>
        <p:nvSpPr>
          <p:cNvPr id="188" name="TextBox 187"/>
          <p:cNvSpPr txBox="1"/>
          <p:nvPr/>
        </p:nvSpPr>
        <p:spPr>
          <a:xfrm>
            <a:off x="7956626" y="240452"/>
            <a:ext cx="518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8386307" y="236199"/>
            <a:ext cx="518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7972466" y="393569"/>
            <a:ext cx="2825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/>
          <p:cNvCxnSpPr/>
          <p:nvPr/>
        </p:nvCxnSpPr>
        <p:spPr>
          <a:xfrm>
            <a:off x="8423112" y="390898"/>
            <a:ext cx="2825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548985" y="2863113"/>
            <a:ext cx="4781061" cy="3671331"/>
          </a:xfrm>
          <a:prstGeom prst="rect">
            <a:avLst/>
          </a:prstGeom>
        </p:spPr>
      </p:pic>
      <p:sp>
        <p:nvSpPr>
          <p:cNvPr id="135" name="TextBox 134"/>
          <p:cNvSpPr txBox="1"/>
          <p:nvPr/>
        </p:nvSpPr>
        <p:spPr>
          <a:xfrm>
            <a:off x="9253998" y="3704670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9296612" y="5388051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</p:spTree>
    <p:extLst>
      <p:ext uri="{BB962C8B-B14F-4D97-AF65-F5344CB8AC3E}">
        <p14:creationId xmlns:p14="http://schemas.microsoft.com/office/powerpoint/2010/main" val="41002289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170" y="-34471"/>
            <a:ext cx="5127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5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blots for Figure 4B.</a:t>
            </a:r>
            <a:endParaRPr lang="en-GB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267974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4 B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7582" y="682523"/>
            <a:ext cx="1814663" cy="2039932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3664" y="2858056"/>
            <a:ext cx="1854589" cy="1887886"/>
          </a:xfrm>
          <a:prstGeom prst="rect">
            <a:avLst/>
          </a:prstGeom>
        </p:spPr>
      </p:pic>
      <p:pic>
        <p:nvPicPr>
          <p:cNvPr id="88" name="Picture 8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3668" y="746315"/>
            <a:ext cx="1477849" cy="2020732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8737" y="4857987"/>
            <a:ext cx="1470024" cy="1968268"/>
          </a:xfrm>
          <a:prstGeom prst="rect">
            <a:avLst/>
          </a:prstGeom>
        </p:spPr>
      </p:pic>
      <p:grpSp>
        <p:nvGrpSpPr>
          <p:cNvPr id="113" name="Group 112"/>
          <p:cNvGrpSpPr/>
          <p:nvPr/>
        </p:nvGrpSpPr>
        <p:grpSpPr>
          <a:xfrm>
            <a:off x="4104762" y="2846525"/>
            <a:ext cx="2154266" cy="1623881"/>
            <a:chOff x="2039291" y="2846525"/>
            <a:chExt cx="2154266" cy="1623881"/>
          </a:xfrm>
        </p:grpSpPr>
        <p:grpSp>
          <p:nvGrpSpPr>
            <p:cNvPr id="112" name="Group 111"/>
            <p:cNvGrpSpPr/>
            <p:nvPr/>
          </p:nvGrpSpPr>
          <p:grpSpPr>
            <a:xfrm>
              <a:off x="2039291" y="2846525"/>
              <a:ext cx="2154266" cy="1623881"/>
              <a:chOff x="2039291" y="2846525"/>
              <a:chExt cx="2154266" cy="1623881"/>
            </a:xfrm>
          </p:grpSpPr>
          <p:pic>
            <p:nvPicPr>
              <p:cNvPr id="91" name="Picture 9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039291" y="3062128"/>
                <a:ext cx="2154266" cy="1408278"/>
              </a:xfrm>
              <a:prstGeom prst="rect">
                <a:avLst/>
              </a:prstGeom>
            </p:spPr>
          </p:pic>
          <p:sp>
            <p:nvSpPr>
              <p:cNvPr id="110" name="TextBox 109"/>
              <p:cNvSpPr txBox="1"/>
              <p:nvPr/>
            </p:nvSpPr>
            <p:spPr>
              <a:xfrm>
                <a:off x="2242516" y="2846525"/>
                <a:ext cx="590512" cy="2540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7 days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2822692" y="2850447"/>
                <a:ext cx="7647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/>
                  <a:t>14 days</a:t>
                </a:r>
              </a:p>
            </p:txBody>
          </p:sp>
        </p:grpSp>
        <p:cxnSp>
          <p:nvCxnSpPr>
            <p:cNvPr id="102" name="Straight Connector 101"/>
            <p:cNvCxnSpPr/>
            <p:nvPr/>
          </p:nvCxnSpPr>
          <p:spPr>
            <a:xfrm>
              <a:off x="2173910" y="3062128"/>
              <a:ext cx="5801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2851934" y="3062128"/>
              <a:ext cx="5801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8" name="Picture 9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65150" y="4881544"/>
            <a:ext cx="1352080" cy="1799729"/>
          </a:xfrm>
          <a:prstGeom prst="rect">
            <a:avLst/>
          </a:prstGeom>
        </p:spPr>
      </p:pic>
      <p:grpSp>
        <p:nvGrpSpPr>
          <p:cNvPr id="131" name="Group 130"/>
          <p:cNvGrpSpPr/>
          <p:nvPr/>
        </p:nvGrpSpPr>
        <p:grpSpPr>
          <a:xfrm>
            <a:off x="7080686" y="402915"/>
            <a:ext cx="2853998" cy="2058601"/>
            <a:chOff x="3204288" y="465465"/>
            <a:chExt cx="2853998" cy="2058601"/>
          </a:xfrm>
        </p:grpSpPr>
        <p:grpSp>
          <p:nvGrpSpPr>
            <p:cNvPr id="109" name="Group 108"/>
            <p:cNvGrpSpPr/>
            <p:nvPr/>
          </p:nvGrpSpPr>
          <p:grpSpPr>
            <a:xfrm>
              <a:off x="3729840" y="465465"/>
              <a:ext cx="2328446" cy="2058601"/>
              <a:chOff x="3729840" y="465465"/>
              <a:chExt cx="2328446" cy="2058601"/>
            </a:xfrm>
          </p:grpSpPr>
          <p:grpSp>
            <p:nvGrpSpPr>
              <p:cNvPr id="108" name="Group 107"/>
              <p:cNvGrpSpPr/>
              <p:nvPr/>
            </p:nvGrpSpPr>
            <p:grpSpPr>
              <a:xfrm>
                <a:off x="3729840" y="465465"/>
                <a:ext cx="2328446" cy="2058601"/>
                <a:chOff x="3729840" y="465465"/>
                <a:chExt cx="2328446" cy="2058601"/>
              </a:xfrm>
            </p:grpSpPr>
            <p:pic>
              <p:nvPicPr>
                <p:cNvPr id="96" name="Picture 95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729840" y="711687"/>
                  <a:ext cx="2275206" cy="1812379"/>
                </a:xfrm>
                <a:prstGeom prst="rect">
                  <a:avLst/>
                </a:prstGeom>
              </p:spPr>
            </p:pic>
            <p:sp>
              <p:nvSpPr>
                <p:cNvPr id="106" name="TextBox 105"/>
                <p:cNvSpPr txBox="1"/>
                <p:nvPr/>
              </p:nvSpPr>
              <p:spPr>
                <a:xfrm>
                  <a:off x="3894402" y="465465"/>
                  <a:ext cx="15295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7 days</a:t>
                  </a: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4528744" y="465465"/>
                  <a:ext cx="15295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14 days</a:t>
                  </a:r>
                </a:p>
              </p:txBody>
            </p:sp>
          </p:grpSp>
          <p:cxnSp>
            <p:nvCxnSpPr>
              <p:cNvPr id="104" name="Straight Connector 103"/>
              <p:cNvCxnSpPr/>
              <p:nvPr/>
            </p:nvCxnSpPr>
            <p:spPr>
              <a:xfrm>
                <a:off x="3842604" y="694978"/>
                <a:ext cx="5801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4520628" y="694978"/>
                <a:ext cx="5801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9" name="Rectangle 128"/>
            <p:cNvSpPr/>
            <p:nvPr/>
          </p:nvSpPr>
          <p:spPr>
            <a:xfrm>
              <a:off x="3204288" y="1456268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132" name="Group 131"/>
          <p:cNvGrpSpPr/>
          <p:nvPr/>
        </p:nvGrpSpPr>
        <p:grpSpPr>
          <a:xfrm>
            <a:off x="7148488" y="2631838"/>
            <a:ext cx="2285256" cy="2129528"/>
            <a:chOff x="3931072" y="2721485"/>
            <a:chExt cx="2285256" cy="2129528"/>
          </a:xfrm>
        </p:grpSpPr>
        <p:pic>
          <p:nvPicPr>
            <p:cNvPr id="78" name="Picture 7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489500" y="2721485"/>
              <a:ext cx="1726828" cy="2129528"/>
            </a:xfrm>
            <a:prstGeom prst="rect">
              <a:avLst/>
            </a:prstGeom>
          </p:spPr>
        </p:pic>
        <p:sp>
          <p:nvSpPr>
            <p:cNvPr id="130" name="Rectangle 129"/>
            <p:cNvSpPr/>
            <p:nvPr/>
          </p:nvSpPr>
          <p:spPr>
            <a:xfrm>
              <a:off x="3931072" y="3937925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7176295" y="5140803"/>
            <a:ext cx="2426534" cy="1426588"/>
            <a:chOff x="3958879" y="5230450"/>
            <a:chExt cx="2426534" cy="1426588"/>
          </a:xfrm>
        </p:grpSpPr>
        <p:pic>
          <p:nvPicPr>
            <p:cNvPr id="100" name="Picture 9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01586" y="5230450"/>
              <a:ext cx="1883827" cy="1426588"/>
            </a:xfrm>
            <a:prstGeom prst="rect">
              <a:avLst/>
            </a:prstGeom>
          </p:spPr>
        </p:pic>
        <p:sp>
          <p:nvSpPr>
            <p:cNvPr id="133" name="Rectangle 132"/>
            <p:cNvSpPr/>
            <p:nvPr/>
          </p:nvSpPr>
          <p:spPr>
            <a:xfrm>
              <a:off x="3958879" y="5636525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9626051" y="1270607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3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9677624" y="3531354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3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9808872" y="5441370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3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167959" y="949273"/>
            <a:ext cx="1121885" cy="1606338"/>
            <a:chOff x="1167959" y="949273"/>
            <a:chExt cx="1121885" cy="1606338"/>
          </a:xfrm>
        </p:grpSpPr>
        <p:grpSp>
          <p:nvGrpSpPr>
            <p:cNvPr id="51" name="Group 50"/>
            <p:cNvGrpSpPr/>
            <p:nvPr/>
          </p:nvGrpSpPr>
          <p:grpSpPr>
            <a:xfrm>
              <a:off x="1167959" y="949273"/>
              <a:ext cx="1113081" cy="1606338"/>
              <a:chOff x="2387042" y="4984173"/>
              <a:chExt cx="1113081" cy="1606338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2387042" y="4984173"/>
                <a:ext cx="1113081" cy="1420527"/>
                <a:chOff x="10899914" y="455650"/>
                <a:chExt cx="1113081" cy="1420527"/>
              </a:xfrm>
            </p:grpSpPr>
            <p:sp>
              <p:nvSpPr>
                <p:cNvPr id="54" name="TextBox 53"/>
                <p:cNvSpPr txBox="1"/>
                <p:nvPr/>
              </p:nvSpPr>
              <p:spPr>
                <a:xfrm>
                  <a:off x="10912961" y="455650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10899914" y="567695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0</a:t>
                  </a:r>
                  <a:r>
                    <a:rPr lang="en-GB" sz="1000" b="1" dirty="0"/>
                    <a:t>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10906438" y="732252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 10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10976949" y="834265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7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1003569" y="1025409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10996393" y="1176314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37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10992479" y="1328951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10985753" y="1660733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</p:grpSp>
          <p:sp>
            <p:nvSpPr>
              <p:cNvPr id="53" name="TextBox 52"/>
              <p:cNvSpPr txBox="1"/>
              <p:nvPr/>
            </p:nvSpPr>
            <p:spPr>
              <a:xfrm>
                <a:off x="2472881" y="637506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1280418" y="199809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1017726" y="3070117"/>
            <a:ext cx="1121885" cy="1606338"/>
            <a:chOff x="1167959" y="949273"/>
            <a:chExt cx="1121885" cy="1606338"/>
          </a:xfrm>
        </p:grpSpPr>
        <p:grpSp>
          <p:nvGrpSpPr>
            <p:cNvPr id="64" name="Group 63"/>
            <p:cNvGrpSpPr/>
            <p:nvPr/>
          </p:nvGrpSpPr>
          <p:grpSpPr>
            <a:xfrm>
              <a:off x="1167959" y="949273"/>
              <a:ext cx="1113081" cy="1606338"/>
              <a:chOff x="2387042" y="4984173"/>
              <a:chExt cx="1113081" cy="1606338"/>
            </a:xfrm>
          </p:grpSpPr>
          <p:grpSp>
            <p:nvGrpSpPr>
              <p:cNvPr id="66" name="Group 65"/>
              <p:cNvGrpSpPr/>
              <p:nvPr/>
            </p:nvGrpSpPr>
            <p:grpSpPr>
              <a:xfrm>
                <a:off x="2387042" y="4984173"/>
                <a:ext cx="1113081" cy="1420527"/>
                <a:chOff x="10899914" y="455650"/>
                <a:chExt cx="1113081" cy="1420527"/>
              </a:xfrm>
            </p:grpSpPr>
            <p:sp>
              <p:nvSpPr>
                <p:cNvPr id="68" name="TextBox 67"/>
                <p:cNvSpPr txBox="1"/>
                <p:nvPr/>
              </p:nvSpPr>
              <p:spPr>
                <a:xfrm>
                  <a:off x="10912961" y="455650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10899914" y="567695"/>
                  <a:ext cx="100942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0</a:t>
                  </a:r>
                  <a:r>
                    <a:rPr lang="en-GB" sz="1000" b="1" dirty="0"/>
                    <a:t> </a:t>
                  </a:r>
                  <a:r>
                    <a:rPr lang="en-GB" sz="1000" b="1" dirty="0" err="1"/>
                    <a:t>kDa</a:t>
                  </a:r>
                  <a:endParaRPr lang="en-GB" sz="1000" b="1" dirty="0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10906438" y="732252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 10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10976949" y="834265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7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11003569" y="1025409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50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10996393" y="1176314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37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10992479" y="1328951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2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10985753" y="1660733"/>
                  <a:ext cx="100942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/>
                    <a:t>15 </a:t>
                  </a:r>
                  <a:r>
                    <a:rPr lang="en-GB" sz="800" b="1" dirty="0" err="1"/>
                    <a:t>kDa</a:t>
                  </a:r>
                  <a:endParaRPr lang="en-GB" sz="800" b="1" dirty="0"/>
                </a:p>
              </p:txBody>
            </p:sp>
          </p:grpSp>
          <p:sp>
            <p:nvSpPr>
              <p:cNvPr id="67" name="TextBox 66"/>
              <p:cNvSpPr txBox="1"/>
              <p:nvPr/>
            </p:nvSpPr>
            <p:spPr>
              <a:xfrm>
                <a:off x="2472881" y="637506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1280418" y="199809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76" name="Group 75"/>
          <p:cNvGrpSpPr/>
          <p:nvPr/>
        </p:nvGrpSpPr>
        <p:grpSpPr>
          <a:xfrm>
            <a:off x="1148719" y="4949538"/>
            <a:ext cx="1141125" cy="1584355"/>
            <a:chOff x="1167959" y="949273"/>
            <a:chExt cx="1141125" cy="1584355"/>
          </a:xfrm>
        </p:grpSpPr>
        <p:grpSp>
          <p:nvGrpSpPr>
            <p:cNvPr id="80" name="Group 79"/>
            <p:cNvGrpSpPr/>
            <p:nvPr/>
          </p:nvGrpSpPr>
          <p:grpSpPr>
            <a:xfrm>
              <a:off x="1167959" y="949273"/>
              <a:ext cx="1141125" cy="1584355"/>
              <a:chOff x="10899914" y="455650"/>
              <a:chExt cx="1141125" cy="1584355"/>
            </a:xfrm>
          </p:grpSpPr>
          <p:sp>
            <p:nvSpPr>
              <p:cNvPr id="83" name="TextBox 82"/>
              <p:cNvSpPr txBox="1"/>
              <p:nvPr/>
            </p:nvSpPr>
            <p:spPr>
              <a:xfrm>
                <a:off x="10912961" y="45565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0899914" y="567695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10906438" y="73225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10976949" y="83426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1031613" y="111676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11031613" y="1276063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11010128" y="141849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0993396" y="182456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>
              <a:off x="1299658" y="211543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94" name="Group 93"/>
          <p:cNvGrpSpPr/>
          <p:nvPr/>
        </p:nvGrpSpPr>
        <p:grpSpPr>
          <a:xfrm>
            <a:off x="3771004" y="899320"/>
            <a:ext cx="1143255" cy="1708198"/>
            <a:chOff x="1167959" y="949273"/>
            <a:chExt cx="1143255" cy="1708198"/>
          </a:xfrm>
        </p:grpSpPr>
        <p:grpSp>
          <p:nvGrpSpPr>
            <p:cNvPr id="99" name="Group 98"/>
            <p:cNvGrpSpPr/>
            <p:nvPr/>
          </p:nvGrpSpPr>
          <p:grpSpPr>
            <a:xfrm>
              <a:off x="1167959" y="949273"/>
              <a:ext cx="1138314" cy="1708198"/>
              <a:chOff x="10899914" y="455650"/>
              <a:chExt cx="1138314" cy="1708198"/>
            </a:xfrm>
          </p:grpSpPr>
          <p:sp>
            <p:nvSpPr>
              <p:cNvPr id="119" name="TextBox 118"/>
              <p:cNvSpPr txBox="1"/>
              <p:nvPr/>
            </p:nvSpPr>
            <p:spPr>
              <a:xfrm>
                <a:off x="10912961" y="45565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10899914" y="567695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0906438" y="73225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10976949" y="83426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11024939" y="120471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11028802" y="137195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11017983" y="1596564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11025053" y="1948404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97" name="TextBox 96"/>
            <p:cNvSpPr txBox="1"/>
            <p:nvPr/>
          </p:nvSpPr>
          <p:spPr>
            <a:xfrm>
              <a:off x="1301788" y="224066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44" name="Group 143"/>
          <p:cNvGrpSpPr/>
          <p:nvPr/>
        </p:nvGrpSpPr>
        <p:grpSpPr>
          <a:xfrm>
            <a:off x="3835689" y="4988022"/>
            <a:ext cx="1159015" cy="1653593"/>
            <a:chOff x="1167959" y="949273"/>
            <a:chExt cx="1159015" cy="1653593"/>
          </a:xfrm>
        </p:grpSpPr>
        <p:grpSp>
          <p:nvGrpSpPr>
            <p:cNvPr id="147" name="Group 146"/>
            <p:cNvGrpSpPr/>
            <p:nvPr/>
          </p:nvGrpSpPr>
          <p:grpSpPr>
            <a:xfrm>
              <a:off x="1167959" y="949273"/>
              <a:ext cx="1159015" cy="1653593"/>
              <a:chOff x="10899914" y="455650"/>
              <a:chExt cx="1159015" cy="1653593"/>
            </a:xfrm>
          </p:grpSpPr>
          <p:sp>
            <p:nvSpPr>
              <p:cNvPr id="149" name="TextBox 148"/>
              <p:cNvSpPr txBox="1"/>
              <p:nvPr/>
            </p:nvSpPr>
            <p:spPr>
              <a:xfrm>
                <a:off x="10912961" y="45565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10899914" y="567695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10906438" y="73225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10976949" y="83426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11024939" y="120471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11028802" y="137195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11036903" y="1552556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11049503" y="189379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146" name="TextBox 145"/>
            <p:cNvSpPr txBox="1"/>
            <p:nvPr/>
          </p:nvSpPr>
          <p:spPr>
            <a:xfrm>
              <a:off x="1317548" y="219550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14" name="TextBox 113"/>
          <p:cNvSpPr txBox="1"/>
          <p:nvPr/>
        </p:nvSpPr>
        <p:spPr>
          <a:xfrm>
            <a:off x="3682229" y="3809954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5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sp>
        <p:nvSpPr>
          <p:cNvPr id="115" name="TextBox 114"/>
          <p:cNvSpPr txBox="1"/>
          <p:nvPr/>
        </p:nvSpPr>
        <p:spPr>
          <a:xfrm>
            <a:off x="3689299" y="4161794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5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sp>
        <p:nvSpPr>
          <p:cNvPr id="116" name="TextBox 115"/>
          <p:cNvSpPr txBox="1"/>
          <p:nvPr/>
        </p:nvSpPr>
        <p:spPr>
          <a:xfrm>
            <a:off x="3697989" y="3960427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</p:spTree>
    <p:extLst>
      <p:ext uri="{BB962C8B-B14F-4D97-AF65-F5344CB8AC3E}">
        <p14:creationId xmlns:p14="http://schemas.microsoft.com/office/powerpoint/2010/main" val="4143275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6605" y="-45932"/>
            <a:ext cx="4360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6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blots for Figure 4B.</a:t>
            </a:r>
            <a:endParaRPr lang="en-GB" b="1" dirty="0"/>
          </a:p>
        </p:txBody>
      </p:sp>
      <p:sp>
        <p:nvSpPr>
          <p:cNvPr id="6" name="TextBox 5"/>
          <p:cNvSpPr txBox="1"/>
          <p:nvPr/>
        </p:nvSpPr>
        <p:spPr>
          <a:xfrm>
            <a:off x="0" y="249173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5 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334512" y="197612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5 H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2873004" y="5127895"/>
            <a:ext cx="1447519" cy="1513018"/>
            <a:chOff x="1966240" y="5103478"/>
            <a:chExt cx="1447519" cy="1513018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2"/>
            <a:srcRect l="7962" t="3826" r="9732" b="5987"/>
            <a:stretch/>
          </p:blipFill>
          <p:spPr>
            <a:xfrm>
              <a:off x="1966240" y="5103478"/>
              <a:ext cx="611497" cy="1513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26121" y="5840879"/>
              <a:ext cx="987638" cy="323116"/>
            </a:xfrm>
            <a:prstGeom prst="rect">
              <a:avLst/>
            </a:prstGeom>
          </p:spPr>
        </p:pic>
      </p:grpSp>
      <p:grpSp>
        <p:nvGrpSpPr>
          <p:cNvPr id="26" name="Group 25"/>
          <p:cNvGrpSpPr/>
          <p:nvPr/>
        </p:nvGrpSpPr>
        <p:grpSpPr>
          <a:xfrm>
            <a:off x="2872131" y="3802430"/>
            <a:ext cx="1473643" cy="1225408"/>
            <a:chOff x="1966241" y="3779325"/>
            <a:chExt cx="1473643" cy="1225408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66241" y="3779325"/>
              <a:ext cx="631557" cy="12254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52246" y="4385675"/>
              <a:ext cx="987638" cy="323116"/>
            </a:xfrm>
            <a:prstGeom prst="rect">
              <a:avLst/>
            </a:prstGeom>
          </p:spPr>
        </p:pic>
      </p:grpSp>
      <p:grpSp>
        <p:nvGrpSpPr>
          <p:cNvPr id="31" name="Group 30"/>
          <p:cNvGrpSpPr/>
          <p:nvPr/>
        </p:nvGrpSpPr>
        <p:grpSpPr>
          <a:xfrm>
            <a:off x="2887977" y="2398124"/>
            <a:ext cx="1478091" cy="1319045"/>
            <a:chOff x="1987918" y="2320461"/>
            <a:chExt cx="1478091" cy="1319045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87918" y="2320461"/>
              <a:ext cx="645847" cy="13190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78371" y="2979983"/>
              <a:ext cx="987638" cy="323116"/>
            </a:xfrm>
            <a:prstGeom prst="rect">
              <a:avLst/>
            </a:prstGeom>
          </p:spPr>
        </p:pic>
      </p:grpSp>
      <p:grpSp>
        <p:nvGrpSpPr>
          <p:cNvPr id="87" name="Group 86"/>
          <p:cNvGrpSpPr/>
          <p:nvPr/>
        </p:nvGrpSpPr>
        <p:grpSpPr>
          <a:xfrm>
            <a:off x="7990769" y="5691665"/>
            <a:ext cx="2052391" cy="623224"/>
            <a:chOff x="6641275" y="5666596"/>
            <a:chExt cx="1840211" cy="623224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214833" y="5715054"/>
              <a:ext cx="524474" cy="5747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2" name="Group 51"/>
            <p:cNvGrpSpPr/>
            <p:nvPr/>
          </p:nvGrpSpPr>
          <p:grpSpPr>
            <a:xfrm>
              <a:off x="7730598" y="5682878"/>
              <a:ext cx="750888" cy="246221"/>
              <a:chOff x="11305028" y="4800523"/>
              <a:chExt cx="750888" cy="246221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11497414" y="4800523"/>
                <a:ext cx="5585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  <p:cxnSp>
            <p:nvCxnSpPr>
              <p:cNvPr id="28" name="Straight Arrow Connector 27"/>
              <p:cNvCxnSpPr/>
              <p:nvPr/>
            </p:nvCxnSpPr>
            <p:spPr>
              <a:xfrm flipH="1">
                <a:off x="11305028" y="4929653"/>
                <a:ext cx="23593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Rectangle 72"/>
            <p:cNvSpPr/>
            <p:nvPr/>
          </p:nvSpPr>
          <p:spPr>
            <a:xfrm>
              <a:off x="6641275" y="5666596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82" name="Group 81"/>
          <p:cNvGrpSpPr/>
          <p:nvPr/>
        </p:nvGrpSpPr>
        <p:grpSpPr>
          <a:xfrm>
            <a:off x="7965044" y="2493618"/>
            <a:ext cx="2225118" cy="942243"/>
            <a:chOff x="6570664" y="2384822"/>
            <a:chExt cx="2225118" cy="942243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134462" y="2384844"/>
              <a:ext cx="918517" cy="9422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6" name="Group 55"/>
            <p:cNvGrpSpPr/>
            <p:nvPr/>
          </p:nvGrpSpPr>
          <p:grpSpPr>
            <a:xfrm>
              <a:off x="7922984" y="2384822"/>
              <a:ext cx="872798" cy="246221"/>
              <a:chOff x="11305028" y="4800523"/>
              <a:chExt cx="872798" cy="246221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11497413" y="4800523"/>
                <a:ext cx="6804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  <p:cxnSp>
            <p:nvCxnSpPr>
              <p:cNvPr id="58" name="Straight Arrow Connector 57"/>
              <p:cNvCxnSpPr/>
              <p:nvPr/>
            </p:nvCxnSpPr>
            <p:spPr>
              <a:xfrm flipH="1">
                <a:off x="11305028" y="4929653"/>
                <a:ext cx="23593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Rectangle 73"/>
            <p:cNvSpPr/>
            <p:nvPr/>
          </p:nvSpPr>
          <p:spPr>
            <a:xfrm>
              <a:off x="6570664" y="2386338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7931508" y="4130353"/>
            <a:ext cx="2419162" cy="833760"/>
            <a:chOff x="6575409" y="4078475"/>
            <a:chExt cx="2419162" cy="833760"/>
          </a:xfrm>
        </p:grpSpPr>
        <p:grpSp>
          <p:nvGrpSpPr>
            <p:cNvPr id="80" name="Group 79"/>
            <p:cNvGrpSpPr/>
            <p:nvPr/>
          </p:nvGrpSpPr>
          <p:grpSpPr>
            <a:xfrm>
              <a:off x="7153106" y="4078475"/>
              <a:ext cx="1841465" cy="833760"/>
              <a:chOff x="7153106" y="4078475"/>
              <a:chExt cx="1841465" cy="833760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153106" y="4082389"/>
                <a:ext cx="976289" cy="8298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53" name="Group 52"/>
              <p:cNvGrpSpPr/>
              <p:nvPr/>
            </p:nvGrpSpPr>
            <p:grpSpPr>
              <a:xfrm>
                <a:off x="7966529" y="4078475"/>
                <a:ext cx="1028042" cy="246221"/>
                <a:chOff x="11305028" y="4800523"/>
                <a:chExt cx="1028042" cy="246221"/>
              </a:xfrm>
            </p:grpSpPr>
            <p:sp>
              <p:nvSpPr>
                <p:cNvPr id="54" name="TextBox 53"/>
                <p:cNvSpPr txBox="1"/>
                <p:nvPr/>
              </p:nvSpPr>
              <p:spPr>
                <a:xfrm>
                  <a:off x="11497413" y="4800523"/>
                  <a:ext cx="83565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B</a:t>
                  </a:r>
                </a:p>
              </p:txBody>
            </p:sp>
            <p:cxnSp>
              <p:nvCxnSpPr>
                <p:cNvPr id="55" name="Straight Arrow Connector 54"/>
                <p:cNvCxnSpPr/>
                <p:nvPr/>
              </p:nvCxnSpPr>
              <p:spPr>
                <a:xfrm flipH="1">
                  <a:off x="11305028" y="4929653"/>
                  <a:ext cx="235931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5" name="Rectangle 74"/>
            <p:cNvSpPr/>
            <p:nvPr/>
          </p:nvSpPr>
          <p:spPr>
            <a:xfrm>
              <a:off x="6575409" y="4108676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83" name="Group 82"/>
          <p:cNvGrpSpPr/>
          <p:nvPr/>
        </p:nvGrpSpPr>
        <p:grpSpPr>
          <a:xfrm>
            <a:off x="7936756" y="730352"/>
            <a:ext cx="2253407" cy="1071590"/>
            <a:chOff x="6586196" y="599824"/>
            <a:chExt cx="2253407" cy="1071590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9"/>
            <a:srcRect t="640" r="24913"/>
            <a:stretch/>
          </p:blipFill>
          <p:spPr>
            <a:xfrm>
              <a:off x="7153106" y="767322"/>
              <a:ext cx="899873" cy="9040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9" name="Group 58"/>
            <p:cNvGrpSpPr/>
            <p:nvPr/>
          </p:nvGrpSpPr>
          <p:grpSpPr>
            <a:xfrm>
              <a:off x="7966529" y="827166"/>
              <a:ext cx="873074" cy="246221"/>
              <a:chOff x="11305028" y="4800523"/>
              <a:chExt cx="873074" cy="246221"/>
            </a:xfrm>
          </p:grpSpPr>
          <p:sp>
            <p:nvSpPr>
              <p:cNvPr id="60" name="TextBox 59"/>
              <p:cNvSpPr txBox="1"/>
              <p:nvPr/>
            </p:nvSpPr>
            <p:spPr>
              <a:xfrm>
                <a:off x="11497413" y="4800523"/>
                <a:ext cx="6806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  <p:cxnSp>
            <p:nvCxnSpPr>
              <p:cNvPr id="61" name="Straight Arrow Connector 60"/>
              <p:cNvCxnSpPr/>
              <p:nvPr/>
            </p:nvCxnSpPr>
            <p:spPr>
              <a:xfrm flipH="1">
                <a:off x="11305028" y="4929653"/>
                <a:ext cx="23593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844351" y="599824"/>
              <a:ext cx="1242085" cy="221651"/>
            </a:xfrm>
            <a:prstGeom prst="rect">
              <a:avLst/>
            </a:prstGeom>
          </p:spPr>
        </p:pic>
        <p:sp>
          <p:nvSpPr>
            <p:cNvPr id="76" name="Rectangle 75"/>
            <p:cNvSpPr/>
            <p:nvPr/>
          </p:nvSpPr>
          <p:spPr>
            <a:xfrm>
              <a:off x="6586196" y="811001"/>
              <a:ext cx="6383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000" dirty="0"/>
            </a:p>
          </p:txBody>
        </p:sp>
      </p:grpSp>
      <p:grpSp>
        <p:nvGrpSpPr>
          <p:cNvPr id="92" name="Group 91"/>
          <p:cNvGrpSpPr/>
          <p:nvPr/>
        </p:nvGrpSpPr>
        <p:grpSpPr>
          <a:xfrm>
            <a:off x="6164193" y="720735"/>
            <a:ext cx="2411307" cy="4533939"/>
            <a:chOff x="5921370" y="710366"/>
            <a:chExt cx="2411307" cy="4533939"/>
          </a:xfrm>
        </p:grpSpPr>
        <p:grpSp>
          <p:nvGrpSpPr>
            <p:cNvPr id="86" name="Group 85"/>
            <p:cNvGrpSpPr/>
            <p:nvPr/>
          </p:nvGrpSpPr>
          <p:grpSpPr>
            <a:xfrm>
              <a:off x="6122319" y="3948602"/>
              <a:ext cx="2184284" cy="1295703"/>
              <a:chOff x="5056495" y="3807775"/>
              <a:chExt cx="2184284" cy="1295703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056495" y="3807775"/>
                <a:ext cx="753162" cy="129570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0" name="Straight Arrow Connector 49"/>
              <p:cNvCxnSpPr/>
              <p:nvPr/>
            </p:nvCxnSpPr>
            <p:spPr>
              <a:xfrm flipH="1">
                <a:off x="5744738" y="4269272"/>
                <a:ext cx="308764" cy="683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5969327" y="4149580"/>
                <a:ext cx="12714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NAP</a:t>
                </a:r>
              </a:p>
            </p:txBody>
          </p:sp>
        </p:grpSp>
        <p:grpSp>
          <p:nvGrpSpPr>
            <p:cNvPr id="85" name="Group 84"/>
            <p:cNvGrpSpPr/>
            <p:nvPr/>
          </p:nvGrpSpPr>
          <p:grpSpPr>
            <a:xfrm>
              <a:off x="5921370" y="710366"/>
              <a:ext cx="2411307" cy="3081695"/>
              <a:chOff x="4855582" y="665482"/>
              <a:chExt cx="2411307" cy="3081695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12"/>
              <a:srcRect l="11501" t="3237"/>
              <a:stretch/>
            </p:blipFill>
            <p:spPr>
              <a:xfrm>
                <a:off x="5056495" y="2365120"/>
                <a:ext cx="753162" cy="138205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48" name="Straight Arrow Connector 47"/>
              <p:cNvCxnSpPr/>
              <p:nvPr/>
            </p:nvCxnSpPr>
            <p:spPr>
              <a:xfrm flipH="1">
                <a:off x="5775754" y="2758764"/>
                <a:ext cx="308764" cy="683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>
                <a:off x="5995437" y="2642491"/>
                <a:ext cx="12714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NAP</a:t>
                </a:r>
              </a:p>
            </p:txBody>
          </p:sp>
          <p:grpSp>
            <p:nvGrpSpPr>
              <p:cNvPr id="84" name="Group 83"/>
              <p:cNvGrpSpPr/>
              <p:nvPr/>
            </p:nvGrpSpPr>
            <p:grpSpPr>
              <a:xfrm>
                <a:off x="4855582" y="665482"/>
                <a:ext cx="2339473" cy="1605080"/>
                <a:chOff x="4855582" y="665482"/>
                <a:chExt cx="2339473" cy="1605080"/>
              </a:xfrm>
            </p:grpSpPr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13"/>
                <a:srcRect l="11506" t="2379" r="13406" b="-1"/>
                <a:stretch/>
              </p:blipFill>
              <p:spPr>
                <a:xfrm>
                  <a:off x="5108078" y="808505"/>
                  <a:ext cx="649995" cy="146205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45" name="Straight Arrow Connector 44"/>
                <p:cNvCxnSpPr/>
                <p:nvPr/>
              </p:nvCxnSpPr>
              <p:spPr>
                <a:xfrm flipH="1">
                  <a:off x="5681542" y="1207718"/>
                  <a:ext cx="308764" cy="683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5923603" y="1096295"/>
                  <a:ext cx="127145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AP</a:t>
                  </a:r>
                </a:p>
              </p:txBody>
            </p:sp>
            <p:pic>
              <p:nvPicPr>
                <p:cNvPr id="65" name="Picture 64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4855582" y="665482"/>
                  <a:ext cx="985437" cy="175852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93" name="Group 92"/>
          <p:cNvGrpSpPr/>
          <p:nvPr/>
        </p:nvGrpSpPr>
        <p:grpSpPr>
          <a:xfrm>
            <a:off x="4354902" y="694695"/>
            <a:ext cx="1875088" cy="1602164"/>
            <a:chOff x="3187949" y="625241"/>
            <a:chExt cx="1875088" cy="1602164"/>
          </a:xfrm>
        </p:grpSpPr>
        <p:grpSp>
          <p:nvGrpSpPr>
            <p:cNvPr id="23" name="Group 22"/>
            <p:cNvGrpSpPr/>
            <p:nvPr/>
          </p:nvGrpSpPr>
          <p:grpSpPr>
            <a:xfrm>
              <a:off x="3533808" y="767322"/>
              <a:ext cx="1529229" cy="1460083"/>
              <a:chOff x="3533808" y="767322"/>
              <a:chExt cx="1529229" cy="1460083"/>
            </a:xfrm>
          </p:grpSpPr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14"/>
              <a:srcRect l="5413" t="-474" r="9632" b="1406"/>
              <a:stretch/>
            </p:blipFill>
            <p:spPr>
              <a:xfrm>
                <a:off x="3533808" y="767322"/>
                <a:ext cx="629186" cy="14600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9" name="Straight Arrow Connector 28"/>
              <p:cNvCxnSpPr/>
              <p:nvPr/>
            </p:nvCxnSpPr>
            <p:spPr>
              <a:xfrm flipH="1">
                <a:off x="4156257" y="1818353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4359067" y="1673015"/>
                <a:ext cx="7039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CN</a:t>
                </a:r>
              </a:p>
            </p:txBody>
          </p:sp>
        </p:grpSp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87949" y="625241"/>
              <a:ext cx="985437" cy="175852"/>
            </a:xfrm>
            <a:prstGeom prst="rect">
              <a:avLst/>
            </a:prstGeom>
          </p:spPr>
        </p:pic>
      </p:grpSp>
      <p:grpSp>
        <p:nvGrpSpPr>
          <p:cNvPr id="19" name="Group 18"/>
          <p:cNvGrpSpPr/>
          <p:nvPr/>
        </p:nvGrpSpPr>
        <p:grpSpPr>
          <a:xfrm>
            <a:off x="4701988" y="2413754"/>
            <a:ext cx="1520985" cy="1357040"/>
            <a:chOff x="3527267" y="2320462"/>
            <a:chExt cx="1520985" cy="1357040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15"/>
            <a:srcRect l="9107" t="3997" r="6876"/>
            <a:stretch/>
          </p:blipFill>
          <p:spPr>
            <a:xfrm>
              <a:off x="3527267" y="2320462"/>
              <a:ext cx="635726" cy="1357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1" name="Straight Arrow Connector 40"/>
            <p:cNvCxnSpPr/>
            <p:nvPr/>
          </p:nvCxnSpPr>
          <p:spPr>
            <a:xfrm flipH="1">
              <a:off x="4141472" y="3331538"/>
              <a:ext cx="261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4344282" y="3186200"/>
              <a:ext cx="7039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OCN</a:t>
              </a:r>
            </a:p>
          </p:txBody>
        </p:sp>
      </p:grpSp>
      <p:grpSp>
        <p:nvGrpSpPr>
          <p:cNvPr id="94" name="Group 93"/>
          <p:cNvGrpSpPr/>
          <p:nvPr/>
        </p:nvGrpSpPr>
        <p:grpSpPr>
          <a:xfrm>
            <a:off x="4699931" y="3886802"/>
            <a:ext cx="1583809" cy="1320822"/>
            <a:chOff x="3525924" y="3779325"/>
            <a:chExt cx="1507487" cy="1225408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525924" y="3779325"/>
              <a:ext cx="651102" cy="12254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3" name="Straight Arrow Connector 42"/>
            <p:cNvCxnSpPr/>
            <p:nvPr/>
          </p:nvCxnSpPr>
          <p:spPr>
            <a:xfrm flipH="1">
              <a:off x="4126631" y="4891982"/>
              <a:ext cx="261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4329441" y="4746644"/>
              <a:ext cx="703970" cy="228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OCN</a:t>
              </a:r>
            </a:p>
          </p:txBody>
        </p:sp>
      </p:grpSp>
      <p:grpSp>
        <p:nvGrpSpPr>
          <p:cNvPr id="104" name="Group 103"/>
          <p:cNvGrpSpPr/>
          <p:nvPr/>
        </p:nvGrpSpPr>
        <p:grpSpPr>
          <a:xfrm>
            <a:off x="2629467" y="833517"/>
            <a:ext cx="1787378" cy="1463342"/>
            <a:chOff x="1714500" y="704220"/>
            <a:chExt cx="1787378" cy="1463342"/>
          </a:xfrm>
        </p:grpSpPr>
        <p:pic>
          <p:nvPicPr>
            <p:cNvPr id="63" name="Picture 6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714500" y="704220"/>
              <a:ext cx="985437" cy="175852"/>
            </a:xfrm>
            <a:prstGeom prst="rect">
              <a:avLst/>
            </a:prstGeom>
          </p:spPr>
        </p:pic>
        <p:grpSp>
          <p:nvGrpSpPr>
            <p:cNvPr id="34" name="Group 33"/>
            <p:cNvGrpSpPr/>
            <p:nvPr/>
          </p:nvGrpSpPr>
          <p:grpSpPr>
            <a:xfrm>
              <a:off x="1980622" y="827166"/>
              <a:ext cx="1521256" cy="1340396"/>
              <a:chOff x="1980622" y="827166"/>
              <a:chExt cx="1521256" cy="1340396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17"/>
              <a:srcRect l="12618" t="5503" r="9435"/>
              <a:stretch/>
            </p:blipFill>
            <p:spPr>
              <a:xfrm>
                <a:off x="1980622" y="827166"/>
                <a:ext cx="653143" cy="134039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514240" y="1478806"/>
                <a:ext cx="987638" cy="323116"/>
              </a:xfrm>
              <a:prstGeom prst="rect">
                <a:avLst/>
              </a:prstGeom>
            </p:spPr>
          </p:pic>
        </p:grpSp>
      </p:grpSp>
      <p:grpSp>
        <p:nvGrpSpPr>
          <p:cNvPr id="79" name="Group 78"/>
          <p:cNvGrpSpPr/>
          <p:nvPr/>
        </p:nvGrpSpPr>
        <p:grpSpPr>
          <a:xfrm>
            <a:off x="781927" y="5103191"/>
            <a:ext cx="1596854" cy="1467772"/>
            <a:chOff x="299035" y="5103478"/>
            <a:chExt cx="1596854" cy="1467772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99035" y="5103478"/>
              <a:ext cx="681757" cy="14677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828997" y="5530805"/>
              <a:ext cx="1066892" cy="353599"/>
            </a:xfrm>
            <a:prstGeom prst="rect">
              <a:avLst/>
            </a:prstGeom>
          </p:spPr>
        </p:pic>
      </p:grpSp>
      <p:grpSp>
        <p:nvGrpSpPr>
          <p:cNvPr id="78" name="Group 77"/>
          <p:cNvGrpSpPr/>
          <p:nvPr/>
        </p:nvGrpSpPr>
        <p:grpSpPr>
          <a:xfrm>
            <a:off x="805679" y="3713888"/>
            <a:ext cx="1589665" cy="1306295"/>
            <a:chOff x="316279" y="3662628"/>
            <a:chExt cx="1589665" cy="130629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16279" y="3662628"/>
              <a:ext cx="664515" cy="13062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839052" y="4058797"/>
              <a:ext cx="1066892" cy="353599"/>
            </a:xfrm>
            <a:prstGeom prst="rect">
              <a:avLst/>
            </a:prstGeom>
          </p:spPr>
        </p:pic>
      </p:grpSp>
      <p:grpSp>
        <p:nvGrpSpPr>
          <p:cNvPr id="77" name="Group 76"/>
          <p:cNvGrpSpPr/>
          <p:nvPr/>
        </p:nvGrpSpPr>
        <p:grpSpPr>
          <a:xfrm>
            <a:off x="824564" y="2294046"/>
            <a:ext cx="1596854" cy="1264568"/>
            <a:chOff x="299035" y="2263505"/>
            <a:chExt cx="1596854" cy="126456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99035" y="2263505"/>
              <a:ext cx="707878" cy="12645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828997" y="2823878"/>
              <a:ext cx="1066892" cy="353599"/>
            </a:xfrm>
            <a:prstGeom prst="rect">
              <a:avLst/>
            </a:prstGeom>
          </p:spPr>
        </p:pic>
      </p:grpSp>
      <p:grpSp>
        <p:nvGrpSpPr>
          <p:cNvPr id="47" name="Group 46"/>
          <p:cNvGrpSpPr/>
          <p:nvPr/>
        </p:nvGrpSpPr>
        <p:grpSpPr>
          <a:xfrm>
            <a:off x="569433" y="774323"/>
            <a:ext cx="1839283" cy="1400402"/>
            <a:chOff x="56606" y="704226"/>
            <a:chExt cx="1839283" cy="140040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25156" y="843093"/>
              <a:ext cx="655638" cy="12615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828997" y="1271705"/>
              <a:ext cx="1066892" cy="353599"/>
            </a:xfrm>
            <a:prstGeom prst="rect">
              <a:avLst/>
            </a:prstGeom>
          </p:spPr>
        </p:pic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6606" y="704226"/>
              <a:ext cx="985437" cy="175852"/>
            </a:xfrm>
            <a:prstGeom prst="rect">
              <a:avLst/>
            </a:prstGeom>
          </p:spPr>
        </p:pic>
      </p:grpSp>
      <p:sp>
        <p:nvSpPr>
          <p:cNvPr id="116" name="TextBox 115"/>
          <p:cNvSpPr txBox="1"/>
          <p:nvPr/>
        </p:nvSpPr>
        <p:spPr>
          <a:xfrm>
            <a:off x="10134490" y="863758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4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10213623" y="2601743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4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10251413" y="4307033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4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10261168" y="5729602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4 of 4</a:t>
            </a:r>
          </a:p>
        </p:txBody>
      </p:sp>
      <p:grpSp>
        <p:nvGrpSpPr>
          <p:cNvPr id="120" name="Group 119"/>
          <p:cNvGrpSpPr/>
          <p:nvPr/>
        </p:nvGrpSpPr>
        <p:grpSpPr>
          <a:xfrm>
            <a:off x="305513" y="830139"/>
            <a:ext cx="1134623" cy="1332850"/>
            <a:chOff x="10868923" y="563588"/>
            <a:chExt cx="1134623" cy="1332850"/>
          </a:xfrm>
        </p:grpSpPr>
        <p:sp>
          <p:nvSpPr>
            <p:cNvPr id="121" name="TextBox 120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0886341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0949526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0976949" y="104301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0978389" y="118933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0990095" y="138901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0994120" y="1680994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347946" y="2270459"/>
            <a:ext cx="1092451" cy="989305"/>
            <a:chOff x="10908782" y="457797"/>
            <a:chExt cx="1092451" cy="989305"/>
          </a:xfrm>
        </p:grpSpPr>
        <p:sp>
          <p:nvSpPr>
            <p:cNvPr id="131" name="TextBox 130"/>
            <p:cNvSpPr txBox="1"/>
            <p:nvPr/>
          </p:nvSpPr>
          <p:spPr>
            <a:xfrm>
              <a:off x="10923543" y="45779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0908782" y="577711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0911493" y="71846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0968752" y="81008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0991807" y="107865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0991546" y="123165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39" name="TextBox 138"/>
          <p:cNvSpPr txBox="1"/>
          <p:nvPr/>
        </p:nvSpPr>
        <p:spPr>
          <a:xfrm>
            <a:off x="417122" y="3380858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5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grpSp>
        <p:nvGrpSpPr>
          <p:cNvPr id="140" name="Group 139"/>
          <p:cNvGrpSpPr/>
          <p:nvPr/>
        </p:nvGrpSpPr>
        <p:grpSpPr>
          <a:xfrm>
            <a:off x="310257" y="3621190"/>
            <a:ext cx="1121554" cy="1266638"/>
            <a:chOff x="10868923" y="563588"/>
            <a:chExt cx="1121554" cy="1266638"/>
          </a:xfrm>
        </p:grpSpPr>
        <p:sp>
          <p:nvSpPr>
            <p:cNvPr id="141" name="TextBox 140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10868923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10932108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10966582" y="109562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10957743" y="1215974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0981051" y="138981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10967099" y="1614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49" name="Group 148"/>
          <p:cNvGrpSpPr/>
          <p:nvPr/>
        </p:nvGrpSpPr>
        <p:grpSpPr>
          <a:xfrm>
            <a:off x="287099" y="5040892"/>
            <a:ext cx="1108349" cy="1426579"/>
            <a:chOff x="10868923" y="563588"/>
            <a:chExt cx="1108349" cy="1426579"/>
          </a:xfrm>
        </p:grpSpPr>
        <p:sp>
          <p:nvSpPr>
            <p:cNvPr id="150" name="TextBox 149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10868923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10932108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10966944" y="114768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10966944" y="128566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0967846" y="1544793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0955266" y="1774723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58" name="TextBox 157"/>
          <p:cNvSpPr txBox="1"/>
          <p:nvPr/>
        </p:nvSpPr>
        <p:spPr>
          <a:xfrm>
            <a:off x="438250" y="1773878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2497107" y="1725496"/>
            <a:ext cx="10094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20 </a:t>
            </a:r>
            <a:r>
              <a:rPr lang="en-GB" sz="800" b="1" dirty="0" err="1"/>
              <a:t>kDa</a:t>
            </a:r>
            <a:endParaRPr lang="en-GB" sz="800" b="1" dirty="0"/>
          </a:p>
        </p:txBody>
      </p:sp>
      <p:grpSp>
        <p:nvGrpSpPr>
          <p:cNvPr id="71" name="Group 70"/>
          <p:cNvGrpSpPr/>
          <p:nvPr/>
        </p:nvGrpSpPr>
        <p:grpSpPr>
          <a:xfrm>
            <a:off x="2373551" y="841875"/>
            <a:ext cx="1134952" cy="1512071"/>
            <a:chOff x="2373551" y="841875"/>
            <a:chExt cx="1134952" cy="1512071"/>
          </a:xfrm>
        </p:grpSpPr>
        <p:grpSp>
          <p:nvGrpSpPr>
            <p:cNvPr id="159" name="Group 158"/>
            <p:cNvGrpSpPr/>
            <p:nvPr/>
          </p:nvGrpSpPr>
          <p:grpSpPr>
            <a:xfrm>
              <a:off x="2373551" y="841875"/>
              <a:ext cx="1134952" cy="1195385"/>
              <a:chOff x="10868923" y="563588"/>
              <a:chExt cx="1134952" cy="1195385"/>
            </a:xfrm>
          </p:grpSpPr>
          <p:sp>
            <p:nvSpPr>
              <p:cNvPr id="160" name="TextBox 159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10976949" y="104301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10978389" y="118933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10992479" y="132895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10994449" y="154352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169" name="TextBox 168"/>
            <p:cNvSpPr txBox="1"/>
            <p:nvPr/>
          </p:nvSpPr>
          <p:spPr>
            <a:xfrm>
              <a:off x="2475075" y="213850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71" name="Group 170"/>
          <p:cNvGrpSpPr/>
          <p:nvPr/>
        </p:nvGrpSpPr>
        <p:grpSpPr>
          <a:xfrm>
            <a:off x="2377472" y="2301610"/>
            <a:ext cx="1134952" cy="1195385"/>
            <a:chOff x="10868923" y="563588"/>
            <a:chExt cx="1134952" cy="1195385"/>
          </a:xfrm>
        </p:grpSpPr>
        <p:sp>
          <p:nvSpPr>
            <p:cNvPr id="173" name="TextBox 172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10886341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10949526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0976949" y="104301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10978389" y="118933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10992479" y="132895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0994449" y="1543529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81" name="Group 180"/>
          <p:cNvGrpSpPr/>
          <p:nvPr/>
        </p:nvGrpSpPr>
        <p:grpSpPr>
          <a:xfrm>
            <a:off x="2356051" y="3738157"/>
            <a:ext cx="1134952" cy="1093931"/>
            <a:chOff x="10868923" y="665042"/>
            <a:chExt cx="1134952" cy="1093931"/>
          </a:xfrm>
        </p:grpSpPr>
        <p:sp>
          <p:nvSpPr>
            <p:cNvPr id="183" name="TextBox 182"/>
            <p:cNvSpPr txBox="1"/>
            <p:nvPr/>
          </p:nvSpPr>
          <p:spPr>
            <a:xfrm>
              <a:off x="10886341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0949526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0976949" y="104301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10978389" y="118933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0992479" y="132895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0994449" y="1543529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2356051" y="5092111"/>
            <a:ext cx="1147141" cy="1558716"/>
            <a:chOff x="2356051" y="5092111"/>
            <a:chExt cx="1147141" cy="1558716"/>
          </a:xfrm>
        </p:grpSpPr>
        <p:grpSp>
          <p:nvGrpSpPr>
            <p:cNvPr id="190" name="Group 189"/>
            <p:cNvGrpSpPr/>
            <p:nvPr/>
          </p:nvGrpSpPr>
          <p:grpSpPr>
            <a:xfrm>
              <a:off x="2356051" y="5092111"/>
              <a:ext cx="1147141" cy="1292698"/>
              <a:chOff x="10868923" y="563588"/>
              <a:chExt cx="1147141" cy="1292698"/>
            </a:xfrm>
          </p:grpSpPr>
          <p:sp>
            <p:nvSpPr>
              <p:cNvPr id="191" name="TextBox 190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93" name="TextBox 192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10976949" y="104301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10978389" y="118933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10992479" y="132895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11006638" y="164084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199" name="TextBox 198"/>
            <p:cNvSpPr txBox="1"/>
            <p:nvPr/>
          </p:nvSpPr>
          <p:spPr>
            <a:xfrm>
              <a:off x="2463589" y="6435383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00" name="Group 199"/>
          <p:cNvGrpSpPr/>
          <p:nvPr/>
        </p:nvGrpSpPr>
        <p:grpSpPr>
          <a:xfrm>
            <a:off x="4189937" y="795230"/>
            <a:ext cx="1134952" cy="1498400"/>
            <a:chOff x="2356051" y="5092111"/>
            <a:chExt cx="1134952" cy="1498400"/>
          </a:xfrm>
        </p:grpSpPr>
        <p:grpSp>
          <p:nvGrpSpPr>
            <p:cNvPr id="201" name="Group 200"/>
            <p:cNvGrpSpPr/>
            <p:nvPr/>
          </p:nvGrpSpPr>
          <p:grpSpPr>
            <a:xfrm>
              <a:off x="2356051" y="5092111"/>
              <a:ext cx="1134952" cy="1195385"/>
              <a:chOff x="10868923" y="563588"/>
              <a:chExt cx="1134952" cy="1195385"/>
            </a:xfrm>
          </p:grpSpPr>
          <p:sp>
            <p:nvSpPr>
              <p:cNvPr id="203" name="TextBox 202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10976949" y="104301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10978389" y="118933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10992479" y="132895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10994449" y="154352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202" name="TextBox 201"/>
            <p:cNvSpPr txBox="1"/>
            <p:nvPr/>
          </p:nvSpPr>
          <p:spPr>
            <a:xfrm>
              <a:off x="2472881" y="637506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11" name="Group 210"/>
          <p:cNvGrpSpPr/>
          <p:nvPr/>
        </p:nvGrpSpPr>
        <p:grpSpPr>
          <a:xfrm>
            <a:off x="4187236" y="2331537"/>
            <a:ext cx="1134952" cy="1498400"/>
            <a:chOff x="2356051" y="5092111"/>
            <a:chExt cx="1134952" cy="1498400"/>
          </a:xfrm>
        </p:grpSpPr>
        <p:grpSp>
          <p:nvGrpSpPr>
            <p:cNvPr id="212" name="Group 211"/>
            <p:cNvGrpSpPr/>
            <p:nvPr/>
          </p:nvGrpSpPr>
          <p:grpSpPr>
            <a:xfrm>
              <a:off x="2356051" y="5092111"/>
              <a:ext cx="1134952" cy="1195385"/>
              <a:chOff x="10868923" y="563588"/>
              <a:chExt cx="1134952" cy="1195385"/>
            </a:xfrm>
          </p:grpSpPr>
          <p:sp>
            <p:nvSpPr>
              <p:cNvPr id="214" name="TextBox 213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10976949" y="104301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0978389" y="118933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10992479" y="132895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10994449" y="154352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213" name="TextBox 212"/>
            <p:cNvSpPr txBox="1"/>
            <p:nvPr/>
          </p:nvSpPr>
          <p:spPr>
            <a:xfrm>
              <a:off x="2472881" y="637506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23" name="Group 222"/>
          <p:cNvGrpSpPr/>
          <p:nvPr/>
        </p:nvGrpSpPr>
        <p:grpSpPr>
          <a:xfrm>
            <a:off x="4201857" y="3898650"/>
            <a:ext cx="1109184" cy="1278927"/>
            <a:chOff x="10868923" y="563588"/>
            <a:chExt cx="1109184" cy="1278927"/>
          </a:xfrm>
        </p:grpSpPr>
        <p:sp>
          <p:nvSpPr>
            <p:cNvPr id="225" name="TextBox 224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10886341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10949526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10961287" y="105268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30" name="TextBox 229"/>
            <p:cNvSpPr txBox="1"/>
            <p:nvPr/>
          </p:nvSpPr>
          <p:spPr>
            <a:xfrm>
              <a:off x="10968681" y="1205145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10968681" y="132936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10950834" y="162707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33" name="Group 232"/>
          <p:cNvGrpSpPr/>
          <p:nvPr/>
        </p:nvGrpSpPr>
        <p:grpSpPr>
          <a:xfrm>
            <a:off x="5898934" y="787548"/>
            <a:ext cx="1134952" cy="1498400"/>
            <a:chOff x="2356051" y="5092111"/>
            <a:chExt cx="1134952" cy="1498400"/>
          </a:xfrm>
        </p:grpSpPr>
        <p:grpSp>
          <p:nvGrpSpPr>
            <p:cNvPr id="234" name="Group 233"/>
            <p:cNvGrpSpPr/>
            <p:nvPr/>
          </p:nvGrpSpPr>
          <p:grpSpPr>
            <a:xfrm>
              <a:off x="2356051" y="5092111"/>
              <a:ext cx="1134952" cy="1195385"/>
              <a:chOff x="10868923" y="563588"/>
              <a:chExt cx="1134952" cy="1195385"/>
            </a:xfrm>
          </p:grpSpPr>
          <p:sp>
            <p:nvSpPr>
              <p:cNvPr id="236" name="TextBox 235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10976949" y="1043017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10978389" y="118933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10992479" y="1328951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10994449" y="1543529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235" name="TextBox 234"/>
            <p:cNvSpPr txBox="1"/>
            <p:nvPr/>
          </p:nvSpPr>
          <p:spPr>
            <a:xfrm>
              <a:off x="2472881" y="637506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44" name="Group 243"/>
          <p:cNvGrpSpPr/>
          <p:nvPr/>
        </p:nvGrpSpPr>
        <p:grpSpPr>
          <a:xfrm>
            <a:off x="5829935" y="2349520"/>
            <a:ext cx="1136534" cy="1375290"/>
            <a:chOff x="2356051" y="5092111"/>
            <a:chExt cx="1136534" cy="1375290"/>
          </a:xfrm>
        </p:grpSpPr>
        <p:grpSp>
          <p:nvGrpSpPr>
            <p:cNvPr id="245" name="Group 244"/>
            <p:cNvGrpSpPr/>
            <p:nvPr/>
          </p:nvGrpSpPr>
          <p:grpSpPr>
            <a:xfrm>
              <a:off x="2356051" y="5092111"/>
              <a:ext cx="1136534" cy="1256238"/>
              <a:chOff x="10868923" y="563588"/>
              <a:chExt cx="1136534" cy="1256238"/>
            </a:xfrm>
          </p:grpSpPr>
          <p:sp>
            <p:nvSpPr>
              <p:cNvPr id="247" name="TextBox 246"/>
              <p:cNvSpPr txBox="1"/>
              <p:nvPr/>
            </p:nvSpPr>
            <p:spPr>
              <a:xfrm>
                <a:off x="10901508" y="56358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10886341" y="665042"/>
                <a:ext cx="1009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150</a:t>
                </a:r>
                <a:r>
                  <a:rPr lang="en-GB" sz="1000" b="1" dirty="0"/>
                  <a:t>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10868923" y="803868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 10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10949526" y="9237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7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10987801" y="1093455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5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10976949" y="1270590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37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0976949" y="1465556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5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10996031" y="1604382"/>
                <a:ext cx="1009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/>
                  <a:t>20 </a:t>
                </a:r>
                <a:r>
                  <a:rPr lang="en-GB" sz="800" b="1" dirty="0" err="1"/>
                  <a:t>kDa</a:t>
                </a:r>
                <a:endParaRPr lang="en-GB" sz="800" b="1" dirty="0"/>
              </a:p>
            </p:txBody>
          </p:sp>
        </p:grpSp>
        <p:sp>
          <p:nvSpPr>
            <p:cNvPr id="246" name="TextBox 245"/>
            <p:cNvSpPr txBox="1"/>
            <p:nvPr/>
          </p:nvSpPr>
          <p:spPr>
            <a:xfrm>
              <a:off x="2476667" y="625195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56" name="Group 255"/>
          <p:cNvGrpSpPr/>
          <p:nvPr/>
        </p:nvGrpSpPr>
        <p:grpSpPr>
          <a:xfrm>
            <a:off x="5854531" y="3948743"/>
            <a:ext cx="1132982" cy="1294539"/>
            <a:chOff x="10868923" y="563588"/>
            <a:chExt cx="1132982" cy="1294539"/>
          </a:xfrm>
        </p:grpSpPr>
        <p:sp>
          <p:nvSpPr>
            <p:cNvPr id="258" name="TextBox 257"/>
            <p:cNvSpPr txBox="1"/>
            <p:nvPr/>
          </p:nvSpPr>
          <p:spPr>
            <a:xfrm>
              <a:off x="10901508" y="5635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59" name="TextBox 258"/>
            <p:cNvSpPr txBox="1"/>
            <p:nvPr/>
          </p:nvSpPr>
          <p:spPr>
            <a:xfrm>
              <a:off x="10886341" y="665042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0</a:t>
              </a:r>
              <a:r>
                <a:rPr lang="en-GB" sz="1000" b="1" dirty="0"/>
                <a:t>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10868923" y="80386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 10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61" name="TextBox 260"/>
            <p:cNvSpPr txBox="1"/>
            <p:nvPr/>
          </p:nvSpPr>
          <p:spPr>
            <a:xfrm>
              <a:off x="10949526" y="923782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7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62" name="TextBox 261"/>
            <p:cNvSpPr txBox="1"/>
            <p:nvPr/>
          </p:nvSpPr>
          <p:spPr>
            <a:xfrm>
              <a:off x="10976949" y="104301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50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10978389" y="118933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37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64" name="TextBox 263"/>
            <p:cNvSpPr txBox="1"/>
            <p:nvPr/>
          </p:nvSpPr>
          <p:spPr>
            <a:xfrm>
              <a:off x="10992479" y="132895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2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10961157" y="1642683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6315508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665" y="-43512"/>
            <a:ext cx="6257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7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blots for Figure 7A, 7D and 7E.</a:t>
            </a:r>
            <a:endParaRPr lang="en-GB" b="1" dirty="0"/>
          </a:p>
        </p:txBody>
      </p:sp>
      <p:sp>
        <p:nvSpPr>
          <p:cNvPr id="6" name="TextBox 5"/>
          <p:cNvSpPr txBox="1"/>
          <p:nvPr/>
        </p:nvSpPr>
        <p:spPr>
          <a:xfrm>
            <a:off x="0" y="221041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7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96247" y="2778999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7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37494" y="109649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7E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7093734" y="3505272"/>
            <a:ext cx="1030753" cy="1505400"/>
            <a:chOff x="6780269" y="3402148"/>
            <a:chExt cx="1030753" cy="1651687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80269" y="3402148"/>
              <a:ext cx="1030753" cy="1651687"/>
            </a:xfrm>
            <a:prstGeom prst="rect">
              <a:avLst/>
            </a:prstGeom>
          </p:spPr>
        </p:pic>
        <p:sp>
          <p:nvSpPr>
            <p:cNvPr id="39" name="Rectangle 38"/>
            <p:cNvSpPr/>
            <p:nvPr/>
          </p:nvSpPr>
          <p:spPr>
            <a:xfrm>
              <a:off x="6908602" y="3790362"/>
              <a:ext cx="336973" cy="128996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7114316" y="5108410"/>
            <a:ext cx="983986" cy="1697130"/>
            <a:chOff x="8028278" y="3379426"/>
            <a:chExt cx="937221" cy="1697130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028278" y="3379426"/>
              <a:ext cx="937221" cy="16971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0" name="Rectangle 39"/>
            <p:cNvSpPr/>
            <p:nvPr/>
          </p:nvSpPr>
          <p:spPr>
            <a:xfrm>
              <a:off x="8573626" y="3754803"/>
              <a:ext cx="360221" cy="136477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8170946" y="3505271"/>
            <a:ext cx="999680" cy="1505401"/>
            <a:chOff x="6738701" y="5171659"/>
            <a:chExt cx="999680" cy="1505401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738701" y="5171659"/>
              <a:ext cx="999680" cy="1505401"/>
            </a:xfrm>
            <a:prstGeom prst="rect">
              <a:avLst/>
            </a:prstGeom>
          </p:spPr>
        </p:pic>
        <p:sp>
          <p:nvSpPr>
            <p:cNvPr id="41" name="Rectangle 40"/>
            <p:cNvSpPr/>
            <p:nvPr/>
          </p:nvSpPr>
          <p:spPr>
            <a:xfrm>
              <a:off x="6955331" y="5333332"/>
              <a:ext cx="360221" cy="136477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8213121" y="5105550"/>
            <a:ext cx="949295" cy="1712922"/>
            <a:chOff x="9165626" y="3391989"/>
            <a:chExt cx="915329" cy="1669349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165626" y="3391989"/>
              <a:ext cx="915329" cy="16693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3" name="Rectangle 42"/>
            <p:cNvSpPr/>
            <p:nvPr/>
          </p:nvSpPr>
          <p:spPr>
            <a:xfrm>
              <a:off x="9693202" y="3682730"/>
              <a:ext cx="360318" cy="113926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0</a:t>
              </a: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9285722" y="5115536"/>
            <a:ext cx="970374" cy="1702936"/>
            <a:chOff x="10186979" y="3402148"/>
            <a:chExt cx="1021348" cy="1625897"/>
          </a:xfrm>
        </p:grpSpPr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186979" y="3402148"/>
              <a:ext cx="1021348" cy="1625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" name="Rectangle 45"/>
            <p:cNvSpPr/>
            <p:nvPr/>
          </p:nvSpPr>
          <p:spPr>
            <a:xfrm>
              <a:off x="10779742" y="3813075"/>
              <a:ext cx="390882" cy="107633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9285722" y="3505270"/>
            <a:ext cx="970374" cy="1505401"/>
            <a:chOff x="5228371" y="2660073"/>
            <a:chExt cx="970374" cy="1745076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28371" y="2660073"/>
              <a:ext cx="970374" cy="17450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Rectangle 52"/>
            <p:cNvSpPr/>
            <p:nvPr/>
          </p:nvSpPr>
          <p:spPr>
            <a:xfrm>
              <a:off x="5403851" y="3026765"/>
              <a:ext cx="400402" cy="122836"/>
            </a:xfrm>
            <a:prstGeom prst="rect">
              <a:avLst/>
            </a:prstGeom>
            <a:noFill/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10331861" y="3710959"/>
            <a:ext cx="1054688" cy="202660"/>
            <a:chOff x="974499" y="3189514"/>
            <a:chExt cx="928502" cy="276999"/>
          </a:xfrm>
        </p:grpSpPr>
        <p:cxnSp>
          <p:nvCxnSpPr>
            <p:cNvPr id="57" name="Straight Arrow Connector 56"/>
            <p:cNvCxnSpPr/>
            <p:nvPr/>
          </p:nvCxnSpPr>
          <p:spPr>
            <a:xfrm flipH="1">
              <a:off x="974499" y="3390401"/>
              <a:ext cx="261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1199031" y="3189514"/>
              <a:ext cx="70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DRP1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10290808" y="5432130"/>
            <a:ext cx="1619021" cy="246221"/>
            <a:chOff x="10265408" y="5105204"/>
            <a:chExt cx="1619021" cy="246221"/>
          </a:xfrm>
        </p:grpSpPr>
        <p:sp>
          <p:nvSpPr>
            <p:cNvPr id="59" name="TextBox 58"/>
            <p:cNvSpPr txBox="1"/>
            <p:nvPr/>
          </p:nvSpPr>
          <p:spPr>
            <a:xfrm>
              <a:off x="10494483" y="5105204"/>
              <a:ext cx="1389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RP1-pS637</a:t>
              </a:r>
            </a:p>
          </p:txBody>
        </p:sp>
        <p:cxnSp>
          <p:nvCxnSpPr>
            <p:cNvPr id="60" name="Straight Arrow Connector 59"/>
            <p:cNvCxnSpPr/>
            <p:nvPr/>
          </p:nvCxnSpPr>
          <p:spPr>
            <a:xfrm flipH="1">
              <a:off x="10265408" y="5239539"/>
              <a:ext cx="2973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0" name="Picture 6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63441" y="3291514"/>
            <a:ext cx="1370801" cy="232023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85385" y="3283648"/>
            <a:ext cx="1370801" cy="232023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33072" y="3283648"/>
            <a:ext cx="1370801" cy="232023"/>
          </a:xfrm>
          <a:prstGeom prst="rect">
            <a:avLst/>
          </a:prstGeom>
        </p:spPr>
      </p:pic>
      <p:grpSp>
        <p:nvGrpSpPr>
          <p:cNvPr id="98" name="Group 97"/>
          <p:cNvGrpSpPr/>
          <p:nvPr/>
        </p:nvGrpSpPr>
        <p:grpSpPr>
          <a:xfrm>
            <a:off x="2897788" y="4981824"/>
            <a:ext cx="1714722" cy="1855942"/>
            <a:chOff x="3592485" y="2862810"/>
            <a:chExt cx="1714722" cy="1855942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592485" y="2862810"/>
              <a:ext cx="772157" cy="18559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6" name="Group 25"/>
            <p:cNvGrpSpPr/>
            <p:nvPr/>
          </p:nvGrpSpPr>
          <p:grpSpPr>
            <a:xfrm>
              <a:off x="4278646" y="3258905"/>
              <a:ext cx="1028561" cy="202660"/>
              <a:chOff x="974499" y="3214850"/>
              <a:chExt cx="905501" cy="276999"/>
            </a:xfrm>
          </p:grpSpPr>
          <p:cxnSp>
            <p:nvCxnSpPr>
              <p:cNvPr id="27" name="Straight Arrow Connector 26"/>
              <p:cNvCxnSpPr/>
              <p:nvPr/>
            </p:nvCxnSpPr>
            <p:spPr>
              <a:xfrm flipH="1">
                <a:off x="974499" y="3390401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1176030" y="3214850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grpSp>
        <p:nvGrpSpPr>
          <p:cNvPr id="97" name="Group 96"/>
          <p:cNvGrpSpPr/>
          <p:nvPr/>
        </p:nvGrpSpPr>
        <p:grpSpPr>
          <a:xfrm>
            <a:off x="2886843" y="2919174"/>
            <a:ext cx="1764199" cy="1988890"/>
            <a:chOff x="1762271" y="2795918"/>
            <a:chExt cx="1764199" cy="1988890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762271" y="2795918"/>
              <a:ext cx="774300" cy="19888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5" name="Group 74"/>
            <p:cNvGrpSpPr/>
            <p:nvPr/>
          </p:nvGrpSpPr>
          <p:grpSpPr>
            <a:xfrm>
              <a:off x="2480976" y="3207389"/>
              <a:ext cx="1045494" cy="202660"/>
              <a:chOff x="974499" y="3214850"/>
              <a:chExt cx="920408" cy="276999"/>
            </a:xfrm>
          </p:grpSpPr>
          <p:cxnSp>
            <p:nvCxnSpPr>
              <p:cNvPr id="76" name="Straight Arrow Connector 75"/>
              <p:cNvCxnSpPr/>
              <p:nvPr/>
            </p:nvCxnSpPr>
            <p:spPr>
              <a:xfrm flipH="1">
                <a:off x="974499" y="3390401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TextBox 76"/>
              <p:cNvSpPr txBox="1"/>
              <p:nvPr/>
            </p:nvSpPr>
            <p:spPr>
              <a:xfrm>
                <a:off x="1190937" y="3214850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grpSp>
        <p:nvGrpSpPr>
          <p:cNvPr id="91" name="Group 90"/>
          <p:cNvGrpSpPr/>
          <p:nvPr/>
        </p:nvGrpSpPr>
        <p:grpSpPr>
          <a:xfrm>
            <a:off x="4836576" y="2921663"/>
            <a:ext cx="1697677" cy="858168"/>
            <a:chOff x="3534937" y="5093795"/>
            <a:chExt cx="1697677" cy="858168"/>
          </a:xfrm>
        </p:grpSpPr>
        <p:grpSp>
          <p:nvGrpSpPr>
            <p:cNvPr id="92" name="Group 91"/>
            <p:cNvGrpSpPr/>
            <p:nvPr/>
          </p:nvGrpSpPr>
          <p:grpSpPr>
            <a:xfrm>
              <a:off x="3534937" y="5093795"/>
              <a:ext cx="1697677" cy="858168"/>
              <a:chOff x="2801803" y="5066192"/>
              <a:chExt cx="1697677" cy="858168"/>
            </a:xfrm>
          </p:grpSpPr>
          <p:pic>
            <p:nvPicPr>
              <p:cNvPr id="94" name="Picture 93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801803" y="5094514"/>
                <a:ext cx="976289" cy="8298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5" name="TextBox 94"/>
              <p:cNvSpPr txBox="1"/>
              <p:nvPr/>
            </p:nvSpPr>
            <p:spPr>
              <a:xfrm>
                <a:off x="3795510" y="5066192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ACTB</a:t>
                </a:r>
              </a:p>
            </p:txBody>
          </p:sp>
        </p:grpSp>
        <p:cxnSp>
          <p:nvCxnSpPr>
            <p:cNvPr id="93" name="Straight Arrow Connector 92"/>
            <p:cNvCxnSpPr/>
            <p:nvPr/>
          </p:nvCxnSpPr>
          <p:spPr>
            <a:xfrm flipH="1">
              <a:off x="4295580" y="5237296"/>
              <a:ext cx="2973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Group 95"/>
          <p:cNvGrpSpPr/>
          <p:nvPr/>
        </p:nvGrpSpPr>
        <p:grpSpPr>
          <a:xfrm>
            <a:off x="2862098" y="1159476"/>
            <a:ext cx="1711918" cy="1687363"/>
            <a:chOff x="200794" y="2889701"/>
            <a:chExt cx="1711918" cy="1687363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00794" y="2889701"/>
              <a:ext cx="782852" cy="168736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grpSp>
          <p:nvGrpSpPr>
            <p:cNvPr id="20" name="Group 19"/>
            <p:cNvGrpSpPr/>
            <p:nvPr/>
          </p:nvGrpSpPr>
          <p:grpSpPr>
            <a:xfrm>
              <a:off x="900039" y="3267375"/>
              <a:ext cx="1012673" cy="202660"/>
              <a:chOff x="922321" y="3199354"/>
              <a:chExt cx="891514" cy="276999"/>
            </a:xfrm>
          </p:grpSpPr>
          <p:cxnSp>
            <p:nvCxnSpPr>
              <p:cNvPr id="17" name="Straight Arrow Connector 16"/>
              <p:cNvCxnSpPr/>
              <p:nvPr/>
            </p:nvCxnSpPr>
            <p:spPr>
              <a:xfrm flipH="1">
                <a:off x="922321" y="3390401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1109865" y="3199354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pic>
        <p:nvPicPr>
          <p:cNvPr id="108" name="Picture 10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88576" y="1006315"/>
            <a:ext cx="1642335" cy="293076"/>
          </a:xfrm>
          <a:prstGeom prst="rect">
            <a:avLst/>
          </a:prstGeom>
        </p:spPr>
      </p:pic>
      <p:grpSp>
        <p:nvGrpSpPr>
          <p:cNvPr id="99" name="Group 98"/>
          <p:cNvGrpSpPr/>
          <p:nvPr/>
        </p:nvGrpSpPr>
        <p:grpSpPr>
          <a:xfrm>
            <a:off x="945009" y="3041100"/>
            <a:ext cx="1575203" cy="1949185"/>
            <a:chOff x="2015648" y="921544"/>
            <a:chExt cx="1575203" cy="194918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015648" y="921544"/>
              <a:ext cx="727379" cy="19491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79" name="Straight Arrow Connector 78"/>
            <p:cNvCxnSpPr/>
            <p:nvPr/>
          </p:nvCxnSpPr>
          <p:spPr>
            <a:xfrm flipH="1">
              <a:off x="2675105" y="1347413"/>
              <a:ext cx="261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2886881" y="1191172"/>
              <a:ext cx="70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OPA1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937665" y="5090185"/>
            <a:ext cx="1601181" cy="1699449"/>
            <a:chOff x="4155881" y="1182957"/>
            <a:chExt cx="1601181" cy="169944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155881" y="1182957"/>
              <a:ext cx="731775" cy="169944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81" name="Straight Arrow Connector 80"/>
            <p:cNvCxnSpPr/>
            <p:nvPr/>
          </p:nvCxnSpPr>
          <p:spPr>
            <a:xfrm flipH="1">
              <a:off x="4850220" y="1516045"/>
              <a:ext cx="2618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5053092" y="1392166"/>
              <a:ext cx="70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OPA1</a:t>
              </a:r>
            </a:p>
          </p:txBody>
        </p:sp>
      </p:grpSp>
      <p:pic>
        <p:nvPicPr>
          <p:cNvPr id="109" name="Picture 10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61464" y="961656"/>
            <a:ext cx="1590217" cy="283776"/>
          </a:xfrm>
          <a:prstGeom prst="rect">
            <a:avLst/>
          </a:prstGeom>
        </p:spPr>
      </p:pic>
      <p:grpSp>
        <p:nvGrpSpPr>
          <p:cNvPr id="21" name="Group 20"/>
          <p:cNvGrpSpPr/>
          <p:nvPr/>
        </p:nvGrpSpPr>
        <p:grpSpPr>
          <a:xfrm>
            <a:off x="4273846" y="5115536"/>
            <a:ext cx="2355890" cy="904092"/>
            <a:chOff x="437346" y="5319665"/>
            <a:chExt cx="2355890" cy="904092"/>
          </a:xfrm>
        </p:grpSpPr>
        <p:grpSp>
          <p:nvGrpSpPr>
            <p:cNvPr id="101" name="Group 100"/>
            <p:cNvGrpSpPr/>
            <p:nvPr/>
          </p:nvGrpSpPr>
          <p:grpSpPr>
            <a:xfrm>
              <a:off x="1082258" y="5319665"/>
              <a:ext cx="1710978" cy="904092"/>
              <a:chOff x="200794" y="5054600"/>
              <a:chExt cx="1710978" cy="904092"/>
            </a:xfrm>
          </p:grpSpPr>
          <p:grpSp>
            <p:nvGrpSpPr>
              <p:cNvPr id="89" name="Group 88"/>
              <p:cNvGrpSpPr/>
              <p:nvPr/>
            </p:nvGrpSpPr>
            <p:grpSpPr>
              <a:xfrm>
                <a:off x="200794" y="5054600"/>
                <a:ext cx="1710978" cy="904092"/>
                <a:chOff x="200794" y="5054600"/>
                <a:chExt cx="1710978" cy="904092"/>
              </a:xfrm>
            </p:grpSpPr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16"/>
                <a:srcRect t="640" r="24913"/>
                <a:stretch/>
              </p:blipFill>
              <p:spPr>
                <a:xfrm>
                  <a:off x="200794" y="5054600"/>
                  <a:ext cx="899873" cy="90409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87" name="TextBox 86"/>
                <p:cNvSpPr txBox="1"/>
                <p:nvPr/>
              </p:nvSpPr>
              <p:spPr>
                <a:xfrm>
                  <a:off x="1207802" y="5101633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ACTB</a:t>
                  </a:r>
                </a:p>
              </p:txBody>
            </p:sp>
          </p:grpSp>
          <p:cxnSp>
            <p:nvCxnSpPr>
              <p:cNvPr id="88" name="Straight Arrow Connector 87"/>
              <p:cNvCxnSpPr/>
              <p:nvPr/>
            </p:nvCxnSpPr>
            <p:spPr>
              <a:xfrm flipH="1">
                <a:off x="974738" y="5245134"/>
                <a:ext cx="29738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6" name="Rectangle 105"/>
            <p:cNvSpPr/>
            <p:nvPr/>
          </p:nvSpPr>
          <p:spPr>
            <a:xfrm>
              <a:off x="437346" y="5373098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2kDa -</a:t>
              </a:r>
              <a:endParaRPr lang="en-GB" sz="1200" dirty="0"/>
            </a:p>
          </p:txBody>
        </p:sp>
      </p:grpSp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17"/>
          <a:srcRect l="9003" t="551"/>
          <a:stretch/>
        </p:blipFill>
        <p:spPr>
          <a:xfrm flipH="1">
            <a:off x="7547110" y="764246"/>
            <a:ext cx="1033571" cy="19638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9" name="Picture 118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875512" y="749426"/>
            <a:ext cx="961348" cy="19786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3" name="TextBox 102"/>
          <p:cNvSpPr txBox="1"/>
          <p:nvPr/>
        </p:nvSpPr>
        <p:spPr>
          <a:xfrm>
            <a:off x="10051888" y="1345099"/>
            <a:ext cx="703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ACTB</a:t>
            </a:r>
          </a:p>
        </p:txBody>
      </p:sp>
      <p:cxnSp>
        <p:nvCxnSpPr>
          <p:cNvPr id="107" name="Straight Arrow Connector 106"/>
          <p:cNvCxnSpPr/>
          <p:nvPr/>
        </p:nvCxnSpPr>
        <p:spPr>
          <a:xfrm flipH="1">
            <a:off x="9818824" y="1488600"/>
            <a:ext cx="2973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10087317" y="2149877"/>
            <a:ext cx="703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OM20</a:t>
            </a:r>
          </a:p>
        </p:txBody>
      </p:sp>
      <p:cxnSp>
        <p:nvCxnSpPr>
          <p:cNvPr id="114" name="Straight Arrow Connector 113"/>
          <p:cNvCxnSpPr/>
          <p:nvPr/>
        </p:nvCxnSpPr>
        <p:spPr>
          <a:xfrm flipH="1">
            <a:off x="9854253" y="2293378"/>
            <a:ext cx="2973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6" name="Picture 1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63669" y="463479"/>
            <a:ext cx="2069403" cy="350269"/>
          </a:xfrm>
          <a:prstGeom prst="rect">
            <a:avLst/>
          </a:prstGeom>
        </p:spPr>
      </p:pic>
      <p:pic>
        <p:nvPicPr>
          <p:cNvPr id="117" name="Picture 1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41051" y="502310"/>
            <a:ext cx="1610584" cy="272609"/>
          </a:xfrm>
          <a:prstGeom prst="rect">
            <a:avLst/>
          </a:prstGeom>
        </p:spPr>
      </p:pic>
      <p:grpSp>
        <p:nvGrpSpPr>
          <p:cNvPr id="14" name="Group 13"/>
          <p:cNvGrpSpPr/>
          <p:nvPr/>
        </p:nvGrpSpPr>
        <p:grpSpPr>
          <a:xfrm>
            <a:off x="928558" y="1276994"/>
            <a:ext cx="1600750" cy="1687363"/>
            <a:chOff x="3414680" y="1410397"/>
            <a:chExt cx="1600750" cy="1687363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414680" y="1410397"/>
              <a:ext cx="782852" cy="168736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grpSp>
          <p:nvGrpSpPr>
            <p:cNvPr id="13" name="Group 12"/>
            <p:cNvGrpSpPr/>
            <p:nvPr/>
          </p:nvGrpSpPr>
          <p:grpSpPr>
            <a:xfrm>
              <a:off x="4096548" y="1629598"/>
              <a:ext cx="918882" cy="276999"/>
              <a:chOff x="7431931" y="1185461"/>
              <a:chExt cx="918882" cy="276999"/>
            </a:xfrm>
          </p:grpSpPr>
          <p:cxnSp>
            <p:nvCxnSpPr>
              <p:cNvPr id="11" name="Straight Arrow Connector 10"/>
              <p:cNvCxnSpPr/>
              <p:nvPr/>
            </p:nvCxnSpPr>
            <p:spPr>
              <a:xfrm flipH="1">
                <a:off x="7431931" y="1319951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7646843" y="1185461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OPA1</a:t>
                </a:r>
              </a:p>
            </p:txBody>
          </p:sp>
        </p:grpSp>
      </p:grpSp>
      <p:sp>
        <p:nvSpPr>
          <p:cNvPr id="123" name="Rectangle 122"/>
          <p:cNvSpPr/>
          <p:nvPr/>
        </p:nvSpPr>
        <p:spPr>
          <a:xfrm>
            <a:off x="4191992" y="2988164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42kDa -</a:t>
            </a:r>
            <a:endParaRPr lang="en-GB" sz="1200" dirty="0"/>
          </a:p>
        </p:txBody>
      </p:sp>
      <p:grpSp>
        <p:nvGrpSpPr>
          <p:cNvPr id="34" name="Group 33"/>
          <p:cNvGrpSpPr/>
          <p:nvPr/>
        </p:nvGrpSpPr>
        <p:grpSpPr>
          <a:xfrm>
            <a:off x="4134557" y="957756"/>
            <a:ext cx="2407685" cy="1170148"/>
            <a:chOff x="3939781" y="955208"/>
            <a:chExt cx="2407685" cy="1170148"/>
          </a:xfrm>
        </p:grpSpPr>
        <p:pic>
          <p:nvPicPr>
            <p:cNvPr id="110" name="Picture 109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048555" y="955208"/>
              <a:ext cx="1490221" cy="265931"/>
            </a:xfrm>
            <a:prstGeom prst="rect">
              <a:avLst/>
            </a:prstGeom>
          </p:spPr>
        </p:pic>
        <p:grpSp>
          <p:nvGrpSpPr>
            <p:cNvPr id="33" name="Group 32"/>
            <p:cNvGrpSpPr/>
            <p:nvPr/>
          </p:nvGrpSpPr>
          <p:grpSpPr>
            <a:xfrm>
              <a:off x="3939781" y="1166291"/>
              <a:ext cx="2407685" cy="959065"/>
              <a:chOff x="4223936" y="4898386"/>
              <a:chExt cx="2407685" cy="959065"/>
            </a:xfrm>
          </p:grpSpPr>
          <p:grpSp>
            <p:nvGrpSpPr>
              <p:cNvPr id="102" name="Group 101"/>
              <p:cNvGrpSpPr/>
              <p:nvPr/>
            </p:nvGrpSpPr>
            <p:grpSpPr>
              <a:xfrm>
                <a:off x="4893635" y="4898386"/>
                <a:ext cx="1737986" cy="959065"/>
                <a:chOff x="1885998" y="5077670"/>
                <a:chExt cx="1737986" cy="959065"/>
              </a:xfrm>
            </p:grpSpPr>
            <p:grpSp>
              <p:nvGrpSpPr>
                <p:cNvPr id="90" name="Group 89"/>
                <p:cNvGrpSpPr/>
                <p:nvPr/>
              </p:nvGrpSpPr>
              <p:grpSpPr>
                <a:xfrm>
                  <a:off x="1885998" y="5077670"/>
                  <a:ext cx="1737986" cy="959065"/>
                  <a:chOff x="1674324" y="5077670"/>
                  <a:chExt cx="1737986" cy="959065"/>
                </a:xfrm>
              </p:grpSpPr>
              <p:pic>
                <p:nvPicPr>
                  <p:cNvPr id="30" name="Picture 29"/>
                  <p:cNvPicPr>
                    <a:picLocks noChangeAspect="1"/>
                  </p:cNvPicPr>
                  <p:nvPr/>
                </p:nvPicPr>
                <p:blipFill>
                  <a:blip r:embed="rId19"/>
                  <a:stretch>
                    <a:fillRect/>
                  </a:stretch>
                </p:blipFill>
                <p:spPr>
                  <a:xfrm>
                    <a:off x="1674324" y="5094514"/>
                    <a:ext cx="918517" cy="942221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2708340" y="5077670"/>
                    <a:ext cx="70397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/>
                      <a:t>ACTB</a:t>
                    </a:r>
                  </a:p>
                </p:txBody>
              </p:sp>
            </p:grpSp>
            <p:cxnSp>
              <p:nvCxnSpPr>
                <p:cNvPr id="86" name="Straight Arrow Connector 85"/>
                <p:cNvCxnSpPr/>
                <p:nvPr/>
              </p:nvCxnSpPr>
              <p:spPr>
                <a:xfrm flipH="1">
                  <a:off x="2686950" y="5221171"/>
                  <a:ext cx="29738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4" name="Rectangle 123"/>
              <p:cNvSpPr/>
              <p:nvPr/>
            </p:nvSpPr>
            <p:spPr>
              <a:xfrm>
                <a:off x="4223936" y="4943981"/>
                <a:ext cx="72968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2kDa -</a:t>
                </a:r>
                <a:endParaRPr lang="en-GB" sz="1200" dirty="0"/>
              </a:p>
            </p:txBody>
          </p:sp>
        </p:grpSp>
      </p:grpSp>
      <p:sp>
        <p:nvSpPr>
          <p:cNvPr id="112" name="TextBox 111"/>
          <p:cNvSpPr txBox="1"/>
          <p:nvPr/>
        </p:nvSpPr>
        <p:spPr>
          <a:xfrm>
            <a:off x="7032684" y="3102358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1 of 3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8213121" y="3117834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2 of 3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9346343" y="3103072"/>
            <a:ext cx="10288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Replicate 3 of 3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4432720" y="509300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3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4470153" y="2491999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3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4532641" y="4604831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3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398477" y="1333293"/>
            <a:ext cx="1064731" cy="1201621"/>
            <a:chOff x="398477" y="1333293"/>
            <a:chExt cx="1064731" cy="1201621"/>
          </a:xfrm>
        </p:grpSpPr>
        <p:sp>
          <p:nvSpPr>
            <p:cNvPr id="132" name="TextBox 131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453770" y="207738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51192" y="230969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150" name="Group 149"/>
          <p:cNvGrpSpPr/>
          <p:nvPr/>
        </p:nvGrpSpPr>
        <p:grpSpPr>
          <a:xfrm>
            <a:off x="420451" y="3102358"/>
            <a:ext cx="1064731" cy="1201621"/>
            <a:chOff x="398477" y="1333293"/>
            <a:chExt cx="1064731" cy="1201621"/>
          </a:xfrm>
        </p:grpSpPr>
        <p:sp>
          <p:nvSpPr>
            <p:cNvPr id="151" name="TextBox 150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53770" y="207738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51192" y="230969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158" name="Group 157"/>
          <p:cNvGrpSpPr/>
          <p:nvPr/>
        </p:nvGrpSpPr>
        <p:grpSpPr>
          <a:xfrm>
            <a:off x="398477" y="5094774"/>
            <a:ext cx="1064731" cy="1201621"/>
            <a:chOff x="398477" y="1333293"/>
            <a:chExt cx="1064731" cy="1201621"/>
          </a:xfrm>
        </p:grpSpPr>
        <p:sp>
          <p:nvSpPr>
            <p:cNvPr id="159" name="TextBox 158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53770" y="207738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51192" y="230969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sp>
        <p:nvSpPr>
          <p:cNvPr id="166" name="TextBox 165"/>
          <p:cNvSpPr txBox="1"/>
          <p:nvPr/>
        </p:nvSpPr>
        <p:spPr>
          <a:xfrm>
            <a:off x="457084" y="6367994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1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grpSp>
        <p:nvGrpSpPr>
          <p:cNvPr id="168" name="Group 167"/>
          <p:cNvGrpSpPr/>
          <p:nvPr/>
        </p:nvGrpSpPr>
        <p:grpSpPr>
          <a:xfrm>
            <a:off x="2327495" y="1223687"/>
            <a:ext cx="1064731" cy="1201621"/>
            <a:chOff x="398477" y="1333293"/>
            <a:chExt cx="1064731" cy="1201621"/>
          </a:xfrm>
        </p:grpSpPr>
        <p:sp>
          <p:nvSpPr>
            <p:cNvPr id="169" name="TextBox 168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53770" y="207738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451192" y="230969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176" name="Group 175"/>
          <p:cNvGrpSpPr/>
          <p:nvPr/>
        </p:nvGrpSpPr>
        <p:grpSpPr>
          <a:xfrm>
            <a:off x="2337429" y="3029973"/>
            <a:ext cx="1080002" cy="1332218"/>
            <a:chOff x="398477" y="1333293"/>
            <a:chExt cx="1080002" cy="1332218"/>
          </a:xfrm>
        </p:grpSpPr>
        <p:sp>
          <p:nvSpPr>
            <p:cNvPr id="177" name="TextBox 176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453770" y="1940424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53770" y="213834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469053" y="244029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sp>
        <p:nvSpPr>
          <p:cNvPr id="184" name="TextBox 183"/>
          <p:cNvSpPr txBox="1"/>
          <p:nvPr/>
        </p:nvSpPr>
        <p:spPr>
          <a:xfrm>
            <a:off x="2425014" y="4546936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15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2410493" y="4332224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2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grpSp>
        <p:nvGrpSpPr>
          <p:cNvPr id="186" name="Group 185"/>
          <p:cNvGrpSpPr/>
          <p:nvPr/>
        </p:nvGrpSpPr>
        <p:grpSpPr>
          <a:xfrm>
            <a:off x="2374569" y="4951522"/>
            <a:ext cx="1087922" cy="1583387"/>
            <a:chOff x="10868923" y="665042"/>
            <a:chExt cx="1087922" cy="1583387"/>
          </a:xfrm>
        </p:grpSpPr>
        <p:sp>
          <p:nvSpPr>
            <p:cNvPr id="188" name="TextBox 187"/>
            <p:cNvSpPr txBox="1"/>
            <p:nvPr/>
          </p:nvSpPr>
          <p:spPr>
            <a:xfrm>
              <a:off x="10868923" y="6650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0868923" y="80386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10932108" y="98474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10923399" y="121735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10923399" y="145113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10928278" y="1658931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10930125" y="2002208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10947419" y="1829153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196" name="Group 195"/>
          <p:cNvGrpSpPr/>
          <p:nvPr/>
        </p:nvGrpSpPr>
        <p:grpSpPr>
          <a:xfrm>
            <a:off x="6544705" y="3521752"/>
            <a:ext cx="1096631" cy="1156650"/>
            <a:chOff x="10868923" y="665042"/>
            <a:chExt cx="1096631" cy="1156650"/>
          </a:xfrm>
        </p:grpSpPr>
        <p:sp>
          <p:nvSpPr>
            <p:cNvPr id="198" name="TextBox 197"/>
            <p:cNvSpPr txBox="1"/>
            <p:nvPr/>
          </p:nvSpPr>
          <p:spPr>
            <a:xfrm>
              <a:off x="10868923" y="6650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10868923" y="80386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10923399" y="94120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10956128" y="109682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10941332" y="12337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10944252" y="144971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0956128" y="1575471"/>
              <a:ext cx="1009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  <p:grpSp>
        <p:nvGrpSpPr>
          <p:cNvPr id="206" name="Group 205"/>
          <p:cNvGrpSpPr/>
          <p:nvPr/>
        </p:nvGrpSpPr>
        <p:grpSpPr>
          <a:xfrm>
            <a:off x="6541723" y="5112774"/>
            <a:ext cx="1096631" cy="1310539"/>
            <a:chOff x="10868923" y="665042"/>
            <a:chExt cx="1096631" cy="1310539"/>
          </a:xfrm>
        </p:grpSpPr>
        <p:sp>
          <p:nvSpPr>
            <p:cNvPr id="207" name="TextBox 206"/>
            <p:cNvSpPr txBox="1"/>
            <p:nvPr/>
          </p:nvSpPr>
          <p:spPr>
            <a:xfrm>
              <a:off x="10868923" y="6650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10868923" y="80386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10923399" y="94120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10956128" y="109682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0941332" y="12337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0944252" y="144971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10956128" y="1575471"/>
              <a:ext cx="100942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  15kda</a:t>
              </a:r>
            </a:p>
          </p:txBody>
        </p:sp>
      </p:grpSp>
      <p:grpSp>
        <p:nvGrpSpPr>
          <p:cNvPr id="214" name="Group 213"/>
          <p:cNvGrpSpPr/>
          <p:nvPr/>
        </p:nvGrpSpPr>
        <p:grpSpPr>
          <a:xfrm>
            <a:off x="6968137" y="692739"/>
            <a:ext cx="1135721" cy="1922179"/>
            <a:chOff x="10846630" y="524210"/>
            <a:chExt cx="1135721" cy="1922179"/>
          </a:xfrm>
        </p:grpSpPr>
        <p:sp>
          <p:nvSpPr>
            <p:cNvPr id="215" name="TextBox 214"/>
            <p:cNvSpPr txBox="1"/>
            <p:nvPr/>
          </p:nvSpPr>
          <p:spPr>
            <a:xfrm>
              <a:off x="10846630" y="52421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10868923" y="66504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10868923" y="80386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10923399" y="941200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10923399" y="121735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10923399" y="145113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10972925" y="1815538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10972925" y="2046279"/>
              <a:ext cx="100942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1000" b="1" dirty="0"/>
            </a:p>
            <a:p>
              <a:r>
                <a:rPr lang="en-GB" sz="1000" b="1" dirty="0"/>
                <a:t>1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9598764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3177" y="15116"/>
            <a:ext cx="56389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8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blots for Figure 8A.</a:t>
            </a:r>
            <a:endParaRPr lang="en-GB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83177" y="358761"/>
            <a:ext cx="3300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ull length blots for Figure 8A</a:t>
            </a:r>
          </a:p>
        </p:txBody>
      </p:sp>
      <p:grpSp>
        <p:nvGrpSpPr>
          <p:cNvPr id="45" name="Group 44"/>
          <p:cNvGrpSpPr/>
          <p:nvPr/>
        </p:nvGrpSpPr>
        <p:grpSpPr>
          <a:xfrm>
            <a:off x="745995" y="1116785"/>
            <a:ext cx="1495928" cy="1484183"/>
            <a:chOff x="3930827" y="1180497"/>
            <a:chExt cx="1388573" cy="1352018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30827" y="1180497"/>
              <a:ext cx="536427" cy="13520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31762" y="1647552"/>
              <a:ext cx="987638" cy="323116"/>
            </a:xfrm>
            <a:prstGeom prst="rect">
              <a:avLst/>
            </a:prstGeom>
          </p:spPr>
        </p:pic>
      </p:grpSp>
      <p:grpSp>
        <p:nvGrpSpPr>
          <p:cNvPr id="46" name="Group 45"/>
          <p:cNvGrpSpPr/>
          <p:nvPr/>
        </p:nvGrpSpPr>
        <p:grpSpPr>
          <a:xfrm>
            <a:off x="743819" y="2795467"/>
            <a:ext cx="1534329" cy="1694199"/>
            <a:chOff x="5133343" y="1165063"/>
            <a:chExt cx="1321831" cy="138288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33343" y="1165063"/>
              <a:ext cx="602163" cy="13828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67536" y="1760179"/>
              <a:ext cx="987638" cy="323116"/>
            </a:xfrm>
            <a:prstGeom prst="rect">
              <a:avLst/>
            </a:prstGeom>
          </p:spPr>
        </p:pic>
      </p:grpSp>
      <p:grpSp>
        <p:nvGrpSpPr>
          <p:cNvPr id="47" name="Group 46"/>
          <p:cNvGrpSpPr/>
          <p:nvPr/>
        </p:nvGrpSpPr>
        <p:grpSpPr>
          <a:xfrm>
            <a:off x="779492" y="4641863"/>
            <a:ext cx="1462427" cy="1713654"/>
            <a:chOff x="6273069" y="1151730"/>
            <a:chExt cx="1342724" cy="1372375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73069" y="1151730"/>
              <a:ext cx="483482" cy="1372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28155" y="1849588"/>
              <a:ext cx="987638" cy="323116"/>
            </a:xfrm>
            <a:prstGeom prst="rect">
              <a:avLst/>
            </a:prstGeom>
          </p:spPr>
        </p:pic>
      </p:grpSp>
      <p:grpSp>
        <p:nvGrpSpPr>
          <p:cNvPr id="18" name="Group 17"/>
          <p:cNvGrpSpPr/>
          <p:nvPr/>
        </p:nvGrpSpPr>
        <p:grpSpPr>
          <a:xfrm>
            <a:off x="2751199" y="1078022"/>
            <a:ext cx="1555779" cy="1834835"/>
            <a:chOff x="768218" y="2689354"/>
            <a:chExt cx="1555779" cy="183483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68218" y="2689354"/>
              <a:ext cx="723578" cy="18348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48" name="Group 47"/>
            <p:cNvGrpSpPr/>
            <p:nvPr/>
          </p:nvGrpSpPr>
          <p:grpSpPr>
            <a:xfrm>
              <a:off x="1409686" y="3902006"/>
              <a:ext cx="914311" cy="276999"/>
              <a:chOff x="1169625" y="3177177"/>
              <a:chExt cx="914311" cy="276999"/>
            </a:xfrm>
          </p:grpSpPr>
          <p:cxnSp>
            <p:nvCxnSpPr>
              <p:cNvPr id="49" name="Straight Arrow Connector 48"/>
              <p:cNvCxnSpPr/>
              <p:nvPr/>
            </p:nvCxnSpPr>
            <p:spPr>
              <a:xfrm flipH="1">
                <a:off x="1169625" y="3311421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1379966" y="3177177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p21</a:t>
                </a:r>
              </a:p>
            </p:txBody>
          </p:sp>
        </p:grpSp>
      </p:grpSp>
      <p:grpSp>
        <p:nvGrpSpPr>
          <p:cNvPr id="19" name="Group 18"/>
          <p:cNvGrpSpPr/>
          <p:nvPr/>
        </p:nvGrpSpPr>
        <p:grpSpPr>
          <a:xfrm>
            <a:off x="2781739" y="3020039"/>
            <a:ext cx="1558509" cy="1800740"/>
            <a:chOff x="786670" y="4713272"/>
            <a:chExt cx="1558509" cy="1800740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6670" y="4713272"/>
              <a:ext cx="711204" cy="18007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1" name="Group 50"/>
            <p:cNvGrpSpPr/>
            <p:nvPr/>
          </p:nvGrpSpPr>
          <p:grpSpPr>
            <a:xfrm>
              <a:off x="1438399" y="5843525"/>
              <a:ext cx="906780" cy="276999"/>
              <a:chOff x="1097727" y="3177808"/>
              <a:chExt cx="906780" cy="276999"/>
            </a:xfrm>
          </p:grpSpPr>
          <p:cxnSp>
            <p:nvCxnSpPr>
              <p:cNvPr id="52" name="Straight Arrow Connector 51"/>
              <p:cNvCxnSpPr/>
              <p:nvPr/>
            </p:nvCxnSpPr>
            <p:spPr>
              <a:xfrm flipH="1">
                <a:off x="1097727" y="3323146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/>
              <p:cNvSpPr txBox="1"/>
              <p:nvPr/>
            </p:nvSpPr>
            <p:spPr>
              <a:xfrm>
                <a:off x="1300537" y="3177808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p21</a:t>
                </a:r>
              </a:p>
            </p:txBody>
          </p:sp>
        </p:grpSp>
      </p:grpSp>
      <p:grpSp>
        <p:nvGrpSpPr>
          <p:cNvPr id="83" name="Group 82"/>
          <p:cNvGrpSpPr/>
          <p:nvPr/>
        </p:nvGrpSpPr>
        <p:grpSpPr>
          <a:xfrm>
            <a:off x="4725069" y="3054179"/>
            <a:ext cx="1371418" cy="1543384"/>
            <a:chOff x="4714393" y="1080160"/>
            <a:chExt cx="1371418" cy="154338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14393" y="1080160"/>
              <a:ext cx="694435" cy="154338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grpSp>
          <p:nvGrpSpPr>
            <p:cNvPr id="22" name="Group 21"/>
            <p:cNvGrpSpPr/>
            <p:nvPr/>
          </p:nvGrpSpPr>
          <p:grpSpPr>
            <a:xfrm>
              <a:off x="5179031" y="1306274"/>
              <a:ext cx="906780" cy="276999"/>
              <a:chOff x="1097727" y="3177808"/>
              <a:chExt cx="906780" cy="276999"/>
            </a:xfrm>
          </p:grpSpPr>
          <p:cxnSp>
            <p:nvCxnSpPr>
              <p:cNvPr id="23" name="Straight Arrow Connector 22"/>
              <p:cNvCxnSpPr/>
              <p:nvPr/>
            </p:nvCxnSpPr>
            <p:spPr>
              <a:xfrm flipH="1">
                <a:off x="1097727" y="3323146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1300537" y="3177808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grpSp>
        <p:nvGrpSpPr>
          <p:cNvPr id="82" name="Group 81"/>
          <p:cNvGrpSpPr/>
          <p:nvPr/>
        </p:nvGrpSpPr>
        <p:grpSpPr>
          <a:xfrm>
            <a:off x="4724810" y="1026974"/>
            <a:ext cx="1543905" cy="1838248"/>
            <a:chOff x="4769633" y="2786004"/>
            <a:chExt cx="1543905" cy="1838248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769633" y="2786004"/>
              <a:ext cx="671199" cy="18382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7" name="Group 56"/>
            <p:cNvGrpSpPr/>
            <p:nvPr/>
          </p:nvGrpSpPr>
          <p:grpSpPr>
            <a:xfrm>
              <a:off x="5406758" y="3123143"/>
              <a:ext cx="906780" cy="276999"/>
              <a:chOff x="1097727" y="3177808"/>
              <a:chExt cx="906780" cy="276999"/>
            </a:xfrm>
          </p:grpSpPr>
          <p:cxnSp>
            <p:nvCxnSpPr>
              <p:cNvPr id="58" name="Straight Arrow Connector 57"/>
              <p:cNvCxnSpPr/>
              <p:nvPr/>
            </p:nvCxnSpPr>
            <p:spPr>
              <a:xfrm flipH="1">
                <a:off x="1097727" y="3323146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1300537" y="3177808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grpSp>
        <p:nvGrpSpPr>
          <p:cNvPr id="81" name="Group 80"/>
          <p:cNvGrpSpPr/>
          <p:nvPr/>
        </p:nvGrpSpPr>
        <p:grpSpPr>
          <a:xfrm>
            <a:off x="4872304" y="4835324"/>
            <a:ext cx="1361116" cy="1734036"/>
            <a:chOff x="4872304" y="4835324"/>
            <a:chExt cx="1361116" cy="1734036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872304" y="4835324"/>
              <a:ext cx="495689" cy="173403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grpSp>
          <p:nvGrpSpPr>
            <p:cNvPr id="60" name="Group 59"/>
            <p:cNvGrpSpPr/>
            <p:nvPr/>
          </p:nvGrpSpPr>
          <p:grpSpPr>
            <a:xfrm>
              <a:off x="5326640" y="5132856"/>
              <a:ext cx="906780" cy="276999"/>
              <a:chOff x="1097727" y="3177808"/>
              <a:chExt cx="906780" cy="276999"/>
            </a:xfrm>
          </p:grpSpPr>
          <p:cxnSp>
            <p:nvCxnSpPr>
              <p:cNvPr id="61" name="Straight Arrow Connector 60"/>
              <p:cNvCxnSpPr/>
              <p:nvPr/>
            </p:nvCxnSpPr>
            <p:spPr>
              <a:xfrm flipH="1">
                <a:off x="1097727" y="3323146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1300537" y="3177808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DRP1</a:t>
                </a:r>
              </a:p>
            </p:txBody>
          </p:sp>
        </p:grpSp>
      </p:grpSp>
      <p:grpSp>
        <p:nvGrpSpPr>
          <p:cNvPr id="98" name="Group 97"/>
          <p:cNvGrpSpPr/>
          <p:nvPr/>
        </p:nvGrpSpPr>
        <p:grpSpPr>
          <a:xfrm>
            <a:off x="6804631" y="989153"/>
            <a:ext cx="1507759" cy="5526412"/>
            <a:chOff x="6565094" y="1057161"/>
            <a:chExt cx="1507759" cy="5526412"/>
          </a:xfrm>
        </p:grpSpPr>
        <p:grpSp>
          <p:nvGrpSpPr>
            <p:cNvPr id="80" name="Group 79"/>
            <p:cNvGrpSpPr/>
            <p:nvPr/>
          </p:nvGrpSpPr>
          <p:grpSpPr>
            <a:xfrm>
              <a:off x="6631927" y="4742598"/>
              <a:ext cx="1353156" cy="1840975"/>
              <a:chOff x="6631927" y="4742598"/>
              <a:chExt cx="1353156" cy="1840975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6631927" y="4742598"/>
                <a:ext cx="469934" cy="184097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  <p:grpSp>
            <p:nvGrpSpPr>
              <p:cNvPr id="63" name="Group 62"/>
              <p:cNvGrpSpPr/>
              <p:nvPr/>
            </p:nvGrpSpPr>
            <p:grpSpPr>
              <a:xfrm>
                <a:off x="7078303" y="4936266"/>
                <a:ext cx="906780" cy="276999"/>
                <a:chOff x="757502" y="3213447"/>
                <a:chExt cx="906780" cy="276999"/>
              </a:xfrm>
            </p:grpSpPr>
            <p:cxnSp>
              <p:nvCxnSpPr>
                <p:cNvPr id="64" name="Straight Arrow Connector 63"/>
                <p:cNvCxnSpPr/>
                <p:nvPr/>
              </p:nvCxnSpPr>
              <p:spPr>
                <a:xfrm flipH="1">
                  <a:off x="757502" y="3358785"/>
                  <a:ext cx="26180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TextBox 64"/>
                <p:cNvSpPr txBox="1"/>
                <p:nvPr/>
              </p:nvSpPr>
              <p:spPr>
                <a:xfrm>
                  <a:off x="960312" y="3213447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OPA1</a:t>
                  </a:r>
                </a:p>
              </p:txBody>
            </p:sp>
          </p:grpSp>
        </p:grpSp>
        <p:grpSp>
          <p:nvGrpSpPr>
            <p:cNvPr id="79" name="Group 78"/>
            <p:cNvGrpSpPr/>
            <p:nvPr/>
          </p:nvGrpSpPr>
          <p:grpSpPr>
            <a:xfrm>
              <a:off x="6565094" y="1057161"/>
              <a:ext cx="1507759" cy="3579755"/>
              <a:chOff x="6565094" y="1057161"/>
              <a:chExt cx="1507759" cy="3579755"/>
            </a:xfrm>
          </p:grpSpPr>
          <p:grpSp>
            <p:nvGrpSpPr>
              <p:cNvPr id="78" name="Group 77"/>
              <p:cNvGrpSpPr/>
              <p:nvPr/>
            </p:nvGrpSpPr>
            <p:grpSpPr>
              <a:xfrm>
                <a:off x="6565094" y="2982655"/>
                <a:ext cx="1507759" cy="1654261"/>
                <a:chOff x="6565094" y="2982655"/>
                <a:chExt cx="1507759" cy="1654261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6565094" y="2982655"/>
                  <a:ext cx="591615" cy="165426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25" name="Group 24"/>
                <p:cNvGrpSpPr/>
                <p:nvPr/>
              </p:nvGrpSpPr>
              <p:grpSpPr>
                <a:xfrm>
                  <a:off x="7167276" y="3194799"/>
                  <a:ext cx="905577" cy="276999"/>
                  <a:chOff x="833072" y="5197994"/>
                  <a:chExt cx="905577" cy="276999"/>
                </a:xfrm>
              </p:grpSpPr>
              <p:cxnSp>
                <p:nvCxnSpPr>
                  <p:cNvPr id="26" name="Straight Arrow Connector 25"/>
                  <p:cNvCxnSpPr/>
                  <p:nvPr/>
                </p:nvCxnSpPr>
                <p:spPr>
                  <a:xfrm flipH="1">
                    <a:off x="833072" y="5326942"/>
                    <a:ext cx="261802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1034679" y="5197994"/>
                    <a:ext cx="70397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b="1" dirty="0"/>
                      <a:t>OPA1</a:t>
                    </a:r>
                  </a:p>
                </p:txBody>
              </p:sp>
            </p:grpSp>
          </p:grpSp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573203" y="1057161"/>
                <a:ext cx="633916" cy="1875017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  <p:grpSp>
            <p:nvGrpSpPr>
              <p:cNvPr id="66" name="Group 65"/>
              <p:cNvGrpSpPr/>
              <p:nvPr/>
            </p:nvGrpSpPr>
            <p:grpSpPr>
              <a:xfrm>
                <a:off x="7156709" y="1271967"/>
                <a:ext cx="907445" cy="276999"/>
                <a:chOff x="879538" y="1535107"/>
                <a:chExt cx="907445" cy="276999"/>
              </a:xfrm>
            </p:grpSpPr>
            <p:cxnSp>
              <p:nvCxnSpPr>
                <p:cNvPr id="67" name="Straight Arrow Connector 66"/>
                <p:cNvCxnSpPr/>
                <p:nvPr/>
              </p:nvCxnSpPr>
              <p:spPr>
                <a:xfrm flipH="1">
                  <a:off x="879538" y="1686731"/>
                  <a:ext cx="26180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67"/>
                <p:cNvSpPr txBox="1"/>
                <p:nvPr/>
              </p:nvSpPr>
              <p:spPr>
                <a:xfrm>
                  <a:off x="1083013" y="1535107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OPA1</a:t>
                  </a:r>
                </a:p>
              </p:txBody>
            </p:sp>
          </p:grpSp>
        </p:grpSp>
      </p:grpSp>
      <p:grpSp>
        <p:nvGrpSpPr>
          <p:cNvPr id="99" name="Group 98"/>
          <p:cNvGrpSpPr/>
          <p:nvPr/>
        </p:nvGrpSpPr>
        <p:grpSpPr>
          <a:xfrm>
            <a:off x="8655649" y="891721"/>
            <a:ext cx="1500353" cy="5542696"/>
            <a:chOff x="8655649" y="891721"/>
            <a:chExt cx="1500353" cy="5542696"/>
          </a:xfrm>
        </p:grpSpPr>
        <p:grpSp>
          <p:nvGrpSpPr>
            <p:cNvPr id="75" name="Group 74"/>
            <p:cNvGrpSpPr/>
            <p:nvPr/>
          </p:nvGrpSpPr>
          <p:grpSpPr>
            <a:xfrm>
              <a:off x="8658758" y="891721"/>
              <a:ext cx="1497244" cy="1654261"/>
              <a:chOff x="8658758" y="891721"/>
              <a:chExt cx="1497244" cy="1654261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8658758" y="891721"/>
                <a:ext cx="600436" cy="165426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31" name="Group 30"/>
              <p:cNvGrpSpPr/>
              <p:nvPr/>
            </p:nvGrpSpPr>
            <p:grpSpPr>
              <a:xfrm>
                <a:off x="9249222" y="1571748"/>
                <a:ext cx="906780" cy="276999"/>
                <a:chOff x="1097727" y="3177808"/>
                <a:chExt cx="906780" cy="276999"/>
              </a:xfrm>
            </p:grpSpPr>
            <p:cxnSp>
              <p:nvCxnSpPr>
                <p:cNvPr id="32" name="Straight Arrow Connector 31"/>
                <p:cNvCxnSpPr/>
                <p:nvPr/>
              </p:nvCxnSpPr>
              <p:spPr>
                <a:xfrm flipH="1">
                  <a:off x="1097727" y="3323146"/>
                  <a:ext cx="26180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/>
                <p:cNvSpPr txBox="1"/>
                <p:nvPr/>
              </p:nvSpPr>
              <p:spPr>
                <a:xfrm>
                  <a:off x="1300537" y="3177808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ACTB</a:t>
                  </a:r>
                </a:p>
              </p:txBody>
            </p:sp>
          </p:grpSp>
        </p:grpSp>
        <p:grpSp>
          <p:nvGrpSpPr>
            <p:cNvPr id="76" name="Group 75"/>
            <p:cNvGrpSpPr/>
            <p:nvPr/>
          </p:nvGrpSpPr>
          <p:grpSpPr>
            <a:xfrm>
              <a:off x="8655649" y="2643553"/>
              <a:ext cx="1494246" cy="1818873"/>
              <a:chOff x="8684074" y="2643553"/>
              <a:chExt cx="1494246" cy="1818873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8684074" y="2643553"/>
                <a:ext cx="549804" cy="18188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69" name="Group 68"/>
              <p:cNvGrpSpPr/>
              <p:nvPr/>
            </p:nvGrpSpPr>
            <p:grpSpPr>
              <a:xfrm>
                <a:off x="9233878" y="3437690"/>
                <a:ext cx="944442" cy="276999"/>
                <a:chOff x="1097727" y="3262399"/>
                <a:chExt cx="944442" cy="276999"/>
              </a:xfrm>
            </p:grpSpPr>
            <p:cxnSp>
              <p:nvCxnSpPr>
                <p:cNvPr id="70" name="Straight Arrow Connector 69"/>
                <p:cNvCxnSpPr/>
                <p:nvPr/>
              </p:nvCxnSpPr>
              <p:spPr>
                <a:xfrm flipH="1">
                  <a:off x="1097727" y="3410236"/>
                  <a:ext cx="26180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/>
                <p:cNvSpPr txBox="1"/>
                <p:nvPr/>
              </p:nvSpPr>
              <p:spPr>
                <a:xfrm>
                  <a:off x="1338199" y="3262399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ACTB</a:t>
                  </a:r>
                </a:p>
              </p:txBody>
            </p:sp>
          </p:grpSp>
        </p:grpSp>
        <p:grpSp>
          <p:nvGrpSpPr>
            <p:cNvPr id="77" name="Group 76"/>
            <p:cNvGrpSpPr/>
            <p:nvPr/>
          </p:nvGrpSpPr>
          <p:grpSpPr>
            <a:xfrm>
              <a:off x="8684074" y="4734927"/>
              <a:ext cx="1387210" cy="1699490"/>
              <a:chOff x="8684074" y="4734927"/>
              <a:chExt cx="1387210" cy="1699490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8684074" y="4734927"/>
                <a:ext cx="513457" cy="169949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  <p:grpSp>
            <p:nvGrpSpPr>
              <p:cNvPr id="72" name="Group 71"/>
              <p:cNvGrpSpPr/>
              <p:nvPr/>
            </p:nvGrpSpPr>
            <p:grpSpPr>
              <a:xfrm>
                <a:off x="9164504" y="5397067"/>
                <a:ext cx="906780" cy="276999"/>
                <a:chOff x="1097727" y="3238771"/>
                <a:chExt cx="906780" cy="276999"/>
              </a:xfrm>
            </p:grpSpPr>
            <p:cxnSp>
              <p:nvCxnSpPr>
                <p:cNvPr id="73" name="Straight Arrow Connector 72"/>
                <p:cNvCxnSpPr/>
                <p:nvPr/>
              </p:nvCxnSpPr>
              <p:spPr>
                <a:xfrm flipH="1">
                  <a:off x="1097727" y="3384109"/>
                  <a:ext cx="26180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>
                  <a:off x="1300537" y="3238771"/>
                  <a:ext cx="70397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b="1" dirty="0"/>
                    <a:t>ACTB</a:t>
                  </a:r>
                </a:p>
              </p:txBody>
            </p:sp>
          </p:grpSp>
        </p:grpSp>
      </p:grpSp>
      <p:grpSp>
        <p:nvGrpSpPr>
          <p:cNvPr id="17" name="Group 16"/>
          <p:cNvGrpSpPr/>
          <p:nvPr/>
        </p:nvGrpSpPr>
        <p:grpSpPr>
          <a:xfrm>
            <a:off x="2793639" y="5103753"/>
            <a:ext cx="1471887" cy="1456675"/>
            <a:chOff x="768218" y="1089308"/>
            <a:chExt cx="1471887" cy="1456675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768218" y="1089308"/>
              <a:ext cx="599028" cy="14566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1" name="Group 10"/>
            <p:cNvGrpSpPr/>
            <p:nvPr/>
          </p:nvGrpSpPr>
          <p:grpSpPr>
            <a:xfrm>
              <a:off x="1333325" y="1975427"/>
              <a:ext cx="906780" cy="276999"/>
              <a:chOff x="1097727" y="3177808"/>
              <a:chExt cx="906780" cy="276999"/>
            </a:xfrm>
          </p:grpSpPr>
          <p:cxnSp>
            <p:nvCxnSpPr>
              <p:cNvPr id="12" name="Straight Arrow Connector 11"/>
              <p:cNvCxnSpPr/>
              <p:nvPr/>
            </p:nvCxnSpPr>
            <p:spPr>
              <a:xfrm flipH="1">
                <a:off x="1097727" y="3323146"/>
                <a:ext cx="2618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1300537" y="3177808"/>
                <a:ext cx="7039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p21</a:t>
                </a:r>
              </a:p>
            </p:txBody>
          </p:sp>
        </p:grpSp>
      </p:grpSp>
      <p:sp>
        <p:nvSpPr>
          <p:cNvPr id="93" name="TextBox 92"/>
          <p:cNvSpPr txBox="1"/>
          <p:nvPr/>
        </p:nvSpPr>
        <p:spPr>
          <a:xfrm>
            <a:off x="0" y="894512"/>
            <a:ext cx="1903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vEx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Control  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53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2122297" y="866043"/>
            <a:ext cx="1903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vEx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Control  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53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037647" y="820860"/>
            <a:ext cx="1903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vEx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Control  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53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6115086" y="767422"/>
            <a:ext cx="1903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vEx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Control  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53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7892402" y="694692"/>
            <a:ext cx="1903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vEx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Control  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53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10115888" y="1459543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1 of 3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10196360" y="3311324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2 of 3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10305217" y="5355632"/>
            <a:ext cx="1645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plicate 3 of 3</a:t>
            </a:r>
          </a:p>
        </p:txBody>
      </p:sp>
      <p:grpSp>
        <p:nvGrpSpPr>
          <p:cNvPr id="103" name="Group 102"/>
          <p:cNvGrpSpPr/>
          <p:nvPr/>
        </p:nvGrpSpPr>
        <p:grpSpPr>
          <a:xfrm>
            <a:off x="215452" y="1051721"/>
            <a:ext cx="1064731" cy="1486858"/>
            <a:chOff x="398477" y="1333293"/>
            <a:chExt cx="1064731" cy="1486858"/>
          </a:xfrm>
        </p:grpSpPr>
        <p:sp>
          <p:nvSpPr>
            <p:cNvPr id="104" name="TextBox 103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51192" y="205131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51192" y="2266153"/>
              <a:ext cx="100942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15kDa</a:t>
              </a:r>
            </a:p>
          </p:txBody>
        </p:sp>
      </p:grpSp>
      <p:grpSp>
        <p:nvGrpSpPr>
          <p:cNvPr id="111" name="Group 110"/>
          <p:cNvGrpSpPr/>
          <p:nvPr/>
        </p:nvGrpSpPr>
        <p:grpSpPr>
          <a:xfrm>
            <a:off x="240514" y="4987984"/>
            <a:ext cx="1064731" cy="1399502"/>
            <a:chOff x="398477" y="1333293"/>
            <a:chExt cx="1064731" cy="1399502"/>
          </a:xfrm>
        </p:grpSpPr>
        <p:sp>
          <p:nvSpPr>
            <p:cNvPr id="112" name="TextBox 111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51192" y="205131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35246" y="2178797"/>
              <a:ext cx="100942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endParaRPr lang="en-GB" sz="1000" b="1" dirty="0"/>
            </a:p>
          </p:txBody>
        </p:sp>
      </p:grpSp>
      <p:grpSp>
        <p:nvGrpSpPr>
          <p:cNvPr id="119" name="Group 118"/>
          <p:cNvGrpSpPr/>
          <p:nvPr/>
        </p:nvGrpSpPr>
        <p:grpSpPr>
          <a:xfrm>
            <a:off x="206552" y="2987130"/>
            <a:ext cx="1064731" cy="1399502"/>
            <a:chOff x="398477" y="1333293"/>
            <a:chExt cx="1064731" cy="1399502"/>
          </a:xfrm>
        </p:grpSpPr>
        <p:sp>
          <p:nvSpPr>
            <p:cNvPr id="120" name="TextBox 119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53770" y="187075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51192" y="205131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35246" y="2178797"/>
              <a:ext cx="100942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endParaRPr lang="en-GB" sz="1000" b="1" dirty="0"/>
            </a:p>
          </p:txBody>
        </p:sp>
      </p:grpSp>
      <p:grpSp>
        <p:nvGrpSpPr>
          <p:cNvPr id="127" name="Group 126"/>
          <p:cNvGrpSpPr/>
          <p:nvPr/>
        </p:nvGrpSpPr>
        <p:grpSpPr>
          <a:xfrm>
            <a:off x="4334791" y="4820779"/>
            <a:ext cx="1064731" cy="1958622"/>
            <a:chOff x="398477" y="1333293"/>
            <a:chExt cx="1064731" cy="1958622"/>
          </a:xfrm>
        </p:grpSpPr>
        <p:sp>
          <p:nvSpPr>
            <p:cNvPr id="128" name="TextBox 127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53770" y="200229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53770" y="2206684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23942" y="2584029"/>
              <a:ext cx="100942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endParaRPr lang="en-GB" sz="1000" b="1" dirty="0"/>
            </a:p>
            <a:p>
              <a:endParaRPr lang="en-GB" sz="1000" b="1" dirty="0"/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2278148" y="2957299"/>
            <a:ext cx="1080598" cy="1785744"/>
            <a:chOff x="2231635" y="1060758"/>
            <a:chExt cx="1080598" cy="1785744"/>
          </a:xfrm>
        </p:grpSpPr>
        <p:grpSp>
          <p:nvGrpSpPr>
            <p:cNvPr id="137" name="Group 136"/>
            <p:cNvGrpSpPr/>
            <p:nvPr/>
          </p:nvGrpSpPr>
          <p:grpSpPr>
            <a:xfrm>
              <a:off x="2231635" y="1060758"/>
              <a:ext cx="1064731" cy="1785744"/>
              <a:chOff x="398477" y="1333293"/>
              <a:chExt cx="1064731" cy="1785744"/>
            </a:xfrm>
          </p:grpSpPr>
          <p:sp>
            <p:nvSpPr>
              <p:cNvPr id="139" name="TextBox 138"/>
              <p:cNvSpPr txBox="1"/>
              <p:nvPr/>
            </p:nvSpPr>
            <p:spPr>
              <a:xfrm>
                <a:off x="405355" y="133329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398477" y="14377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402746" y="153408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453782" y="166327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417697" y="1940930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440304" y="2138449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421084" y="2257263"/>
                <a:ext cx="1009426" cy="8617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sz="1000" b="1" dirty="0"/>
              </a:p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 </a:t>
                </a:r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138" name="TextBox 137"/>
            <p:cNvSpPr txBox="1"/>
            <p:nvPr/>
          </p:nvSpPr>
          <p:spPr>
            <a:xfrm>
              <a:off x="2302807" y="2617570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sp>
        <p:nvSpPr>
          <p:cNvPr id="146" name="TextBox 145"/>
          <p:cNvSpPr txBox="1"/>
          <p:nvPr/>
        </p:nvSpPr>
        <p:spPr>
          <a:xfrm>
            <a:off x="2317296" y="4246760"/>
            <a:ext cx="1009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20 </a:t>
            </a:r>
            <a:r>
              <a:rPr lang="en-GB" sz="1000" b="1" dirty="0" err="1"/>
              <a:t>kDa</a:t>
            </a:r>
            <a:endParaRPr lang="en-GB" sz="1000" b="1" dirty="0"/>
          </a:p>
        </p:txBody>
      </p:sp>
      <p:grpSp>
        <p:nvGrpSpPr>
          <p:cNvPr id="147" name="Group 146"/>
          <p:cNvGrpSpPr/>
          <p:nvPr/>
        </p:nvGrpSpPr>
        <p:grpSpPr>
          <a:xfrm>
            <a:off x="2253505" y="4987984"/>
            <a:ext cx="1142296" cy="1590928"/>
            <a:chOff x="2231635" y="1060758"/>
            <a:chExt cx="1142296" cy="1590928"/>
          </a:xfrm>
        </p:grpSpPr>
        <p:grpSp>
          <p:nvGrpSpPr>
            <p:cNvPr id="148" name="Group 147"/>
            <p:cNvGrpSpPr/>
            <p:nvPr/>
          </p:nvGrpSpPr>
          <p:grpSpPr>
            <a:xfrm>
              <a:off x="2231635" y="1060758"/>
              <a:ext cx="1084620" cy="1590928"/>
              <a:chOff x="398477" y="1333293"/>
              <a:chExt cx="1084620" cy="1590928"/>
            </a:xfrm>
          </p:grpSpPr>
          <p:sp>
            <p:nvSpPr>
              <p:cNvPr id="150" name="TextBox 149"/>
              <p:cNvSpPr txBox="1"/>
              <p:nvPr/>
            </p:nvSpPr>
            <p:spPr>
              <a:xfrm>
                <a:off x="405355" y="133329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398477" y="14377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402746" y="153408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453782" y="166327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453770" y="18707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453770" y="2039479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473671" y="2216335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149" name="TextBox 148"/>
            <p:cNvSpPr txBox="1"/>
            <p:nvPr/>
          </p:nvSpPr>
          <p:spPr>
            <a:xfrm>
              <a:off x="2364505" y="2282788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57" name="Group 156"/>
          <p:cNvGrpSpPr/>
          <p:nvPr/>
        </p:nvGrpSpPr>
        <p:grpSpPr>
          <a:xfrm>
            <a:off x="4178794" y="1013643"/>
            <a:ext cx="1099361" cy="1795047"/>
            <a:chOff x="2231635" y="1060758"/>
            <a:chExt cx="1099361" cy="1795047"/>
          </a:xfrm>
        </p:grpSpPr>
        <p:grpSp>
          <p:nvGrpSpPr>
            <p:cNvPr id="158" name="Group 157"/>
            <p:cNvGrpSpPr/>
            <p:nvPr/>
          </p:nvGrpSpPr>
          <p:grpSpPr>
            <a:xfrm>
              <a:off x="2231635" y="1060758"/>
              <a:ext cx="1064731" cy="1795047"/>
              <a:chOff x="398477" y="1333293"/>
              <a:chExt cx="1064731" cy="1795047"/>
            </a:xfrm>
          </p:grpSpPr>
          <p:sp>
            <p:nvSpPr>
              <p:cNvPr id="160" name="TextBox 159"/>
              <p:cNvSpPr txBox="1"/>
              <p:nvPr/>
            </p:nvSpPr>
            <p:spPr>
              <a:xfrm>
                <a:off x="405355" y="133329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398477" y="14377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402746" y="153408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453782" y="166327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453770" y="18707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453770" y="2075761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440304" y="2420454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159" name="TextBox 158"/>
            <p:cNvSpPr txBox="1"/>
            <p:nvPr/>
          </p:nvSpPr>
          <p:spPr>
            <a:xfrm>
              <a:off x="2321570" y="253583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68" name="Group 167"/>
          <p:cNvGrpSpPr/>
          <p:nvPr/>
        </p:nvGrpSpPr>
        <p:grpSpPr>
          <a:xfrm>
            <a:off x="4185119" y="3032836"/>
            <a:ext cx="1099361" cy="1690558"/>
            <a:chOff x="398477" y="1437782"/>
            <a:chExt cx="1099361" cy="1690558"/>
          </a:xfrm>
        </p:grpSpPr>
        <p:sp>
          <p:nvSpPr>
            <p:cNvPr id="171" name="TextBox 170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79588" y="1982837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488412" y="2146527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440304" y="2420454"/>
              <a:ext cx="100942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endParaRPr lang="en-GB" sz="1000" b="1" dirty="0"/>
            </a:p>
            <a:p>
              <a:endParaRPr lang="en-GB" sz="1000" b="1" dirty="0"/>
            </a:p>
          </p:txBody>
        </p:sp>
      </p:grpSp>
      <p:grpSp>
        <p:nvGrpSpPr>
          <p:cNvPr id="177" name="Group 176"/>
          <p:cNvGrpSpPr/>
          <p:nvPr/>
        </p:nvGrpSpPr>
        <p:grpSpPr>
          <a:xfrm>
            <a:off x="2223458" y="1082825"/>
            <a:ext cx="1103176" cy="1820872"/>
            <a:chOff x="2227820" y="1034933"/>
            <a:chExt cx="1103176" cy="1820872"/>
          </a:xfrm>
        </p:grpSpPr>
        <p:grpSp>
          <p:nvGrpSpPr>
            <p:cNvPr id="178" name="Group 177"/>
            <p:cNvGrpSpPr/>
            <p:nvPr/>
          </p:nvGrpSpPr>
          <p:grpSpPr>
            <a:xfrm>
              <a:off x="2227820" y="1034933"/>
              <a:ext cx="1068534" cy="1820872"/>
              <a:chOff x="394662" y="1307468"/>
              <a:chExt cx="1068534" cy="1820872"/>
            </a:xfrm>
          </p:grpSpPr>
          <p:sp>
            <p:nvSpPr>
              <p:cNvPr id="180" name="TextBox 179"/>
              <p:cNvSpPr txBox="1"/>
              <p:nvPr/>
            </p:nvSpPr>
            <p:spPr>
              <a:xfrm>
                <a:off x="404169" y="1307468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1" name="TextBox 180"/>
              <p:cNvSpPr txBox="1"/>
              <p:nvPr/>
            </p:nvSpPr>
            <p:spPr>
              <a:xfrm>
                <a:off x="398586" y="1394518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394662" y="152500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>
                <a:off x="453520" y="1637448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453770" y="18707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453770" y="2101627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440304" y="2420454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179" name="TextBox 178"/>
            <p:cNvSpPr txBox="1"/>
            <p:nvPr/>
          </p:nvSpPr>
          <p:spPr>
            <a:xfrm>
              <a:off x="2321570" y="2535831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198" name="Group 197"/>
          <p:cNvGrpSpPr/>
          <p:nvPr/>
        </p:nvGrpSpPr>
        <p:grpSpPr>
          <a:xfrm>
            <a:off x="6283049" y="961352"/>
            <a:ext cx="1064731" cy="1974510"/>
            <a:chOff x="398477" y="1333293"/>
            <a:chExt cx="1064731" cy="1974510"/>
          </a:xfrm>
        </p:grpSpPr>
        <p:sp>
          <p:nvSpPr>
            <p:cNvPr id="200" name="TextBox 199"/>
            <p:cNvSpPr txBox="1"/>
            <p:nvPr/>
          </p:nvSpPr>
          <p:spPr>
            <a:xfrm>
              <a:off x="405355" y="133329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398477" y="1437782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402746" y="153408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10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53782" y="1663273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75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453782" y="1968079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50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447400" y="2214785"/>
              <a:ext cx="1009426" cy="225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37 </a:t>
              </a:r>
              <a:r>
                <a:rPr lang="en-GB" sz="1000" b="1" dirty="0" err="1"/>
                <a:t>kDa</a:t>
              </a:r>
              <a:endParaRPr lang="en-GB" sz="1000" b="1" dirty="0"/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450352" y="2599917"/>
              <a:ext cx="100942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/>
                <a:t>25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r>
                <a:rPr lang="en-GB" sz="1000" b="1" dirty="0"/>
                <a:t>20 </a:t>
              </a:r>
              <a:r>
                <a:rPr lang="en-GB" sz="1000" b="1" dirty="0" err="1"/>
                <a:t>kDa</a:t>
              </a:r>
              <a:endParaRPr lang="en-GB" sz="1000" b="1" dirty="0"/>
            </a:p>
            <a:p>
              <a:endParaRPr lang="en-GB" sz="1000" b="1" dirty="0"/>
            </a:p>
            <a:p>
              <a:endParaRPr lang="en-GB" sz="1000" b="1" dirty="0"/>
            </a:p>
          </p:txBody>
        </p:sp>
      </p:grpSp>
      <p:grpSp>
        <p:nvGrpSpPr>
          <p:cNvPr id="207" name="Group 206"/>
          <p:cNvGrpSpPr/>
          <p:nvPr/>
        </p:nvGrpSpPr>
        <p:grpSpPr>
          <a:xfrm>
            <a:off x="6289927" y="2933536"/>
            <a:ext cx="1116886" cy="1732563"/>
            <a:chOff x="2231635" y="1060758"/>
            <a:chExt cx="1116886" cy="1732563"/>
          </a:xfrm>
        </p:grpSpPr>
        <p:grpSp>
          <p:nvGrpSpPr>
            <p:cNvPr id="208" name="Group 207"/>
            <p:cNvGrpSpPr/>
            <p:nvPr/>
          </p:nvGrpSpPr>
          <p:grpSpPr>
            <a:xfrm>
              <a:off x="2231635" y="1060758"/>
              <a:ext cx="1064731" cy="1732563"/>
              <a:chOff x="398477" y="1333293"/>
              <a:chExt cx="1064731" cy="1732563"/>
            </a:xfrm>
          </p:grpSpPr>
          <p:sp>
            <p:nvSpPr>
              <p:cNvPr id="210" name="TextBox 209"/>
              <p:cNvSpPr txBox="1"/>
              <p:nvPr/>
            </p:nvSpPr>
            <p:spPr>
              <a:xfrm>
                <a:off x="405355" y="133329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398477" y="14377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402746" y="153408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453782" y="166327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453770" y="18707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446904" y="2032197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440522" y="2357970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209" name="TextBox 208"/>
            <p:cNvSpPr txBox="1"/>
            <p:nvPr/>
          </p:nvSpPr>
          <p:spPr>
            <a:xfrm>
              <a:off x="2339095" y="246669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17" name="Group 216"/>
          <p:cNvGrpSpPr/>
          <p:nvPr/>
        </p:nvGrpSpPr>
        <p:grpSpPr>
          <a:xfrm>
            <a:off x="6317941" y="4674016"/>
            <a:ext cx="1136145" cy="1888324"/>
            <a:chOff x="2231635" y="1060758"/>
            <a:chExt cx="1136145" cy="1888324"/>
          </a:xfrm>
        </p:grpSpPr>
        <p:grpSp>
          <p:nvGrpSpPr>
            <p:cNvPr id="218" name="Group 217"/>
            <p:cNvGrpSpPr/>
            <p:nvPr/>
          </p:nvGrpSpPr>
          <p:grpSpPr>
            <a:xfrm>
              <a:off x="2231635" y="1060758"/>
              <a:ext cx="1100226" cy="1888324"/>
              <a:chOff x="398477" y="1333293"/>
              <a:chExt cx="1100226" cy="1888324"/>
            </a:xfrm>
          </p:grpSpPr>
          <p:sp>
            <p:nvSpPr>
              <p:cNvPr id="220" name="TextBox 219"/>
              <p:cNvSpPr txBox="1"/>
              <p:nvPr/>
            </p:nvSpPr>
            <p:spPr>
              <a:xfrm>
                <a:off x="405355" y="133329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398477" y="14377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402746" y="153408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453782" y="166327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489277" y="201894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65834" y="2234559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65834" y="2513731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219" name="TextBox 218"/>
            <p:cNvSpPr txBox="1"/>
            <p:nvPr/>
          </p:nvSpPr>
          <p:spPr>
            <a:xfrm>
              <a:off x="2358354" y="2669057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27" name="Group 226"/>
          <p:cNvGrpSpPr/>
          <p:nvPr/>
        </p:nvGrpSpPr>
        <p:grpSpPr>
          <a:xfrm>
            <a:off x="8115688" y="859089"/>
            <a:ext cx="1189383" cy="1740894"/>
            <a:chOff x="2233022" y="1164618"/>
            <a:chExt cx="1189383" cy="1740894"/>
          </a:xfrm>
        </p:grpSpPr>
        <p:grpSp>
          <p:nvGrpSpPr>
            <p:cNvPr id="228" name="Group 227"/>
            <p:cNvGrpSpPr/>
            <p:nvPr/>
          </p:nvGrpSpPr>
          <p:grpSpPr>
            <a:xfrm>
              <a:off x="2233022" y="1164618"/>
              <a:ext cx="1098839" cy="1740894"/>
              <a:chOff x="399864" y="1437153"/>
              <a:chExt cx="1098839" cy="1740894"/>
            </a:xfrm>
          </p:grpSpPr>
          <p:sp>
            <p:nvSpPr>
              <p:cNvPr id="230" name="TextBox 229"/>
              <p:cNvSpPr txBox="1"/>
              <p:nvPr/>
            </p:nvSpPr>
            <p:spPr>
              <a:xfrm>
                <a:off x="415724" y="14371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399864" y="154870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421416" y="16533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472229" y="1765817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489277" y="201894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465834" y="2234559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482374" y="2470161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229" name="TextBox 228"/>
            <p:cNvSpPr txBox="1"/>
            <p:nvPr/>
          </p:nvSpPr>
          <p:spPr>
            <a:xfrm>
              <a:off x="2412979" y="252451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37" name="Group 236"/>
          <p:cNvGrpSpPr/>
          <p:nvPr/>
        </p:nvGrpSpPr>
        <p:grpSpPr>
          <a:xfrm>
            <a:off x="8076409" y="2736298"/>
            <a:ext cx="1189383" cy="1740894"/>
            <a:chOff x="2233022" y="1164618"/>
            <a:chExt cx="1189383" cy="1740894"/>
          </a:xfrm>
        </p:grpSpPr>
        <p:grpSp>
          <p:nvGrpSpPr>
            <p:cNvPr id="238" name="Group 237"/>
            <p:cNvGrpSpPr/>
            <p:nvPr/>
          </p:nvGrpSpPr>
          <p:grpSpPr>
            <a:xfrm>
              <a:off x="2233022" y="1164618"/>
              <a:ext cx="1098839" cy="1740894"/>
              <a:chOff x="399864" y="1437153"/>
              <a:chExt cx="1098839" cy="1740894"/>
            </a:xfrm>
          </p:grpSpPr>
          <p:sp>
            <p:nvSpPr>
              <p:cNvPr id="240" name="TextBox 239"/>
              <p:cNvSpPr txBox="1"/>
              <p:nvPr/>
            </p:nvSpPr>
            <p:spPr>
              <a:xfrm>
                <a:off x="415724" y="14371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399864" y="154870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421416" y="16533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472229" y="1765817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489277" y="201894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465834" y="2234559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482374" y="2470161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239" name="TextBox 238"/>
            <p:cNvSpPr txBox="1"/>
            <p:nvPr/>
          </p:nvSpPr>
          <p:spPr>
            <a:xfrm>
              <a:off x="2412979" y="2524516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  <p:grpSp>
        <p:nvGrpSpPr>
          <p:cNvPr id="247" name="Group 246"/>
          <p:cNvGrpSpPr/>
          <p:nvPr/>
        </p:nvGrpSpPr>
        <p:grpSpPr>
          <a:xfrm>
            <a:off x="8165822" y="4756865"/>
            <a:ext cx="1128693" cy="1781000"/>
            <a:chOff x="2233022" y="1164618"/>
            <a:chExt cx="1128693" cy="1781000"/>
          </a:xfrm>
        </p:grpSpPr>
        <p:grpSp>
          <p:nvGrpSpPr>
            <p:cNvPr id="248" name="Group 247"/>
            <p:cNvGrpSpPr/>
            <p:nvPr/>
          </p:nvGrpSpPr>
          <p:grpSpPr>
            <a:xfrm>
              <a:off x="2233022" y="1164618"/>
              <a:ext cx="1098839" cy="1781000"/>
              <a:chOff x="399864" y="1437153"/>
              <a:chExt cx="1098839" cy="1781000"/>
            </a:xfrm>
          </p:grpSpPr>
          <p:sp>
            <p:nvSpPr>
              <p:cNvPr id="250" name="TextBox 249"/>
              <p:cNvSpPr txBox="1"/>
              <p:nvPr/>
            </p:nvSpPr>
            <p:spPr>
              <a:xfrm>
                <a:off x="415724" y="143715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399864" y="154870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421416" y="1653382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10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472229" y="1765817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7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489277" y="2018944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5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450647" y="2164103"/>
                <a:ext cx="1009426" cy="225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37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456330" y="2510267"/>
                <a:ext cx="1009426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/>
                  <a:t>25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r>
                  <a:rPr lang="en-GB" sz="1000" b="1" dirty="0"/>
                  <a:t>20 </a:t>
                </a:r>
                <a:r>
                  <a:rPr lang="en-GB" sz="1000" b="1" dirty="0" err="1"/>
                  <a:t>kDa</a:t>
                </a:r>
                <a:endParaRPr lang="en-GB" sz="1000" b="1" dirty="0"/>
              </a:p>
              <a:p>
                <a:endParaRPr lang="en-GB" sz="1000" b="1" dirty="0"/>
              </a:p>
              <a:p>
                <a:endParaRPr lang="en-GB" sz="1000" b="1" dirty="0"/>
              </a:p>
            </p:txBody>
          </p:sp>
        </p:grpSp>
        <p:sp>
          <p:nvSpPr>
            <p:cNvPr id="249" name="TextBox 248"/>
            <p:cNvSpPr txBox="1"/>
            <p:nvPr/>
          </p:nvSpPr>
          <p:spPr>
            <a:xfrm>
              <a:off x="2352289" y="2559425"/>
              <a:ext cx="1009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/>
                <a:t>15 </a:t>
              </a:r>
              <a:r>
                <a:rPr lang="en-GB" sz="800" b="1" dirty="0" err="1"/>
                <a:t>kDa</a:t>
              </a:r>
              <a:endParaRPr lang="en-GB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407061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36</TotalTime>
  <Words>1348</Words>
  <Application>Microsoft Office PowerPoint</Application>
  <PresentationFormat>Widescreen</PresentationFormat>
  <Paragraphs>58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chan Phadwal</dc:creator>
  <cp:lastModifiedBy>MDPI</cp:lastModifiedBy>
  <cp:revision>172</cp:revision>
  <dcterms:created xsi:type="dcterms:W3CDTF">2022-08-22T10:21:16Z</dcterms:created>
  <dcterms:modified xsi:type="dcterms:W3CDTF">2023-01-13T11:31:32Z</dcterms:modified>
</cp:coreProperties>
</file>